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0" r:id="rId3"/>
    <p:sldId id="261" r:id="rId4"/>
    <p:sldId id="262" r:id="rId5"/>
    <p:sldId id="257" r:id="rId6"/>
    <p:sldId id="259" r:id="rId7"/>
    <p:sldId id="256" r:id="rId8"/>
    <p:sldId id="265" r:id="rId9"/>
    <p:sldId id="266" r:id="rId10"/>
    <p:sldId id="267" r:id="rId11"/>
    <p:sldId id="258" r:id="rId12"/>
    <p:sldId id="268" r:id="rId13"/>
    <p:sldId id="270" r:id="rId14"/>
    <p:sldId id="271" r:id="rId15"/>
    <p:sldId id="272" r:id="rId16"/>
    <p:sldId id="273" r:id="rId17"/>
    <p:sldId id="269" r:id="rId18"/>
    <p:sldId id="263" r:id="rId19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73" d="100"/>
          <a:sy n="73" d="100"/>
        </p:scale>
        <p:origin x="79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D8A30-252C-4C7A-80C1-D82F91B6E4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A41613-C5C5-408E-B6F1-3E4E2A3313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63EAE-2FF3-4E4D-9FC8-57DFFBC58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24D2D-CD5A-4877-8906-25EC1371E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56B2C7-6982-47E1-9415-C34C57D19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5995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A85B7-4F68-463C-A7DC-E0F7264484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044212-9AAC-4E94-9504-5A5981128D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54F2E8-53BE-4FEB-BC99-80F5F14C1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2AAA2D-EA9F-413B-95B3-502895A7E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AE783A-13F8-4065-8D89-86CFA4163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9410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9D958A-B402-4C51-8CAA-3385EDD6DF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E494DF-27F5-41A9-ADCF-1054AD4072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86BD47-B431-4F1C-80E4-DEFC5DFF2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CA66E5-8B37-409F-BEE0-947A6D240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262BC-283A-4C98-A051-086080408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93879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20F66-5112-403A-9CC4-5AB16A2A31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7066E3-51BD-4063-90AE-AD4E29D0E6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9AB112-FA10-4442-9301-9A1EC52A1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2F6488-FF47-468F-9130-1B627794B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B335B7-4F1F-4D1F-AE8A-9420F1E2F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7916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CC7D4F-FF70-4D98-BD50-C88387080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8071F5-AC51-4C64-845F-6B91988578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DAEB63-5B8C-49E5-8E9E-75476E26C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E393D8-CEE4-4A66-8A91-980BDDFA3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E72959-DA0E-427F-9FF3-92B874C06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99053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E497A-885F-4D3F-93F6-CD44E823C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B3CBAB-E8B5-4581-B703-8F244E6E04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07EADC-74A5-441C-B00A-814D04AAA0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37600A-76D0-4AE7-8EEB-30EBBE6E7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022BE3-946E-4476-82BD-DB31C3D79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2634A-CF3D-41AE-91C2-CD7BB9C4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48914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302BE-1410-4219-896F-9980B03EA0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E5D4A7-89D5-4F92-8AE4-8EB3B8D53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651E3A-9A4D-46B8-8311-278ECB0540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2A700F-44D7-4F17-BAA5-5CA244A563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A0819D-8091-4E5A-A1A9-66B7B5497D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B87A31-EC00-4EED-82C0-7A25606F2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104CEE-ACE7-4F7E-A374-0B0CD3312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7DFF04-2A0A-4FB4-B7D4-07CED8449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2348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BD7A26-86D7-496F-B891-EA8284A0F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957B1E-F47D-49DE-8FEA-F1A15DCF1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3648BA-311B-441D-AAFB-3F72074B9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FC09BB-67A0-4008-9213-57B198604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36470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DA0703-2112-4B4A-AD9E-292A01281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4B1B3C-52E4-41D3-AA0D-C86864EBB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4E76CA-B4FE-46CA-ABD5-DBD6B0FE8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07995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26195-0464-4D95-BD62-18C4BB8A8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BB636B-0D5C-49D0-B9F9-274C2C65BA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993349-849A-4B2A-A67C-3B512DB485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D78AA6-80E5-4DBE-B26E-378BF7E07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1E922A-01A9-4913-BB8C-1437D6D62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83049A-C06A-40B2-B376-FF3657964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63158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20B90-1DCB-430D-A8F0-6EDA20FE3D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6A5CA6-E4B4-4887-954D-0358D0EAC3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E21FE5-8831-4A5E-BC97-EE830CE812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C01F14-24F8-477F-8583-679DDAF4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E43443-C7BF-448C-9B77-3073B5FA3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96A75C-1942-481A-A949-06BF4A886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5184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7B9DA1-2BBB-45EA-899F-57C2049C6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E54D9-A20F-41CA-8D4B-F21B262240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764FAB-7107-4BE1-896C-FAC478D4C3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4ABC1-18AF-477B-838C-35D5A591B1B0}" type="datetimeFigureOut">
              <a:rPr lang="nb-NO" smtClean="0"/>
              <a:t>12.06.2020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C560E-5FAC-496A-AC29-1E6B8FF509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378F3F-3481-4999-B690-93BBFB26EC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AFDD32-496D-498E-80D2-FB671997AA7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4307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8.png"/><Relationship Id="rId10" Type="http://schemas.openxmlformats.org/officeDocument/2006/relationships/image" Target="../media/image11.png"/><Relationship Id="rId4" Type="http://schemas.microsoft.com/office/2007/relationships/hdphoto" Target="../media/hdphoto1.wdp"/><Relationship Id="rId9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D:\Research\Denis Paper_10052020\Western Blot_21052020\Denis_p53 2020-05-19 12h06m39s(Composite).tif">
            <a:extLst>
              <a:ext uri="{FF2B5EF4-FFF2-40B4-BE49-F238E27FC236}">
                <a16:creationId xmlns:a16="http://schemas.microsoft.com/office/drawing/2014/main" id="{EF0F3CC3-7BE5-44D5-B502-89E7E526E9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011" b="33134"/>
          <a:stretch/>
        </p:blipFill>
        <p:spPr bwMode="auto">
          <a:xfrm>
            <a:off x="3969894" y="2150693"/>
            <a:ext cx="3057462" cy="5246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E455E79-B1F3-40D4-B0C6-64BA1F961AA4}"/>
              </a:ext>
            </a:extLst>
          </p:cNvPr>
          <p:cNvSpPr txBox="1"/>
          <p:nvPr/>
        </p:nvSpPr>
        <p:spPr>
          <a:xfrm>
            <a:off x="6965352" y="2248123"/>
            <a:ext cx="3935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900" dirty="0"/>
              <a:t>p53</a:t>
            </a:r>
          </a:p>
        </p:txBody>
      </p:sp>
      <p:pic>
        <p:nvPicPr>
          <p:cNvPr id="6" name="Picture 2" descr="D:\Research\Denis Paper_10052020\Western Blot_21052020\Denis_Bcl-xL Com 2020-05-19 12h13m33s(Composite).tif">
            <a:extLst>
              <a:ext uri="{FF2B5EF4-FFF2-40B4-BE49-F238E27FC236}">
                <a16:creationId xmlns:a16="http://schemas.microsoft.com/office/drawing/2014/main" id="{FA303AE7-FEAA-45D0-93F0-D00CB1E3513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973" b="2552"/>
          <a:stretch/>
        </p:blipFill>
        <p:spPr bwMode="auto">
          <a:xfrm>
            <a:off x="3969894" y="2710356"/>
            <a:ext cx="3057462" cy="5246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294B649-A1D2-4387-8717-C776A2E0F463}"/>
              </a:ext>
            </a:extLst>
          </p:cNvPr>
          <p:cNvSpPr txBox="1"/>
          <p:nvPr/>
        </p:nvSpPr>
        <p:spPr>
          <a:xfrm>
            <a:off x="6971231" y="2847203"/>
            <a:ext cx="4555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900" dirty="0" err="1"/>
              <a:t>Bcl-xL</a:t>
            </a:r>
            <a:endParaRPr lang="en-US" sz="900" dirty="0"/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D102CEF0-E5F6-45F1-90FF-A8CD4D65DB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614" b="26429"/>
          <a:stretch/>
        </p:blipFill>
        <p:spPr bwMode="auto">
          <a:xfrm>
            <a:off x="3972378" y="3871218"/>
            <a:ext cx="3054977" cy="52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D19341B-E7F1-4F16-97C9-5D30D4FCCDC1}"/>
              </a:ext>
            </a:extLst>
          </p:cNvPr>
          <p:cNvSpPr txBox="1"/>
          <p:nvPr/>
        </p:nvSpPr>
        <p:spPr>
          <a:xfrm>
            <a:off x="6982864" y="4008410"/>
            <a:ext cx="5261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900" dirty="0"/>
              <a:t>GAPDH</a:t>
            </a:r>
            <a:endParaRPr lang="en-US" sz="9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B7F2599-59C4-40B9-8608-A61B9894E89E}"/>
              </a:ext>
            </a:extLst>
          </p:cNvPr>
          <p:cNvSpPr txBox="1"/>
          <p:nvPr/>
        </p:nvSpPr>
        <p:spPr>
          <a:xfrm>
            <a:off x="4330582" y="1725666"/>
            <a:ext cx="4763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/>
              <a:t>W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C4F571-2F05-4460-8D96-CB791A8E3319}"/>
              </a:ext>
            </a:extLst>
          </p:cNvPr>
          <p:cNvSpPr txBox="1"/>
          <p:nvPr/>
        </p:nvSpPr>
        <p:spPr>
          <a:xfrm>
            <a:off x="5298939" y="1725666"/>
            <a:ext cx="425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err="1"/>
              <a:t>Cyt</a:t>
            </a:r>
            <a:r>
              <a:rPr lang="nb-NO" sz="1200" dirty="0"/>
              <a:t>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55A4F7-E2D9-487F-BC02-25730E83CFC3}"/>
              </a:ext>
            </a:extLst>
          </p:cNvPr>
          <p:cNvSpPr txBox="1"/>
          <p:nvPr/>
        </p:nvSpPr>
        <p:spPr>
          <a:xfrm>
            <a:off x="6137163" y="1725666"/>
            <a:ext cx="46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err="1"/>
              <a:t>Nuc</a:t>
            </a:r>
            <a:r>
              <a:rPr lang="nb-NO" sz="1200" dirty="0"/>
              <a:t>.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C46BA97-4859-48F1-BB9D-DC52BF3B18E1}"/>
              </a:ext>
            </a:extLst>
          </p:cNvPr>
          <p:cNvCxnSpPr/>
          <p:nvPr/>
        </p:nvCxnSpPr>
        <p:spPr>
          <a:xfrm>
            <a:off x="4356432" y="2064220"/>
            <a:ext cx="6443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C2CD629-5B29-4C4F-AEC9-8532C27515EE}"/>
              </a:ext>
            </a:extLst>
          </p:cNvPr>
          <p:cNvCxnSpPr/>
          <p:nvPr/>
        </p:nvCxnSpPr>
        <p:spPr>
          <a:xfrm>
            <a:off x="5201257" y="2064220"/>
            <a:ext cx="6443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6C4D0D2-4D40-48B5-A27E-BDB79D2C1546}"/>
              </a:ext>
            </a:extLst>
          </p:cNvPr>
          <p:cNvCxnSpPr/>
          <p:nvPr/>
        </p:nvCxnSpPr>
        <p:spPr>
          <a:xfrm>
            <a:off x="6085950" y="2064220"/>
            <a:ext cx="6443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8BEDC5B-8A2F-4B2A-9691-577E888E8CF8}"/>
              </a:ext>
            </a:extLst>
          </p:cNvPr>
          <p:cNvSpPr txBox="1"/>
          <p:nvPr/>
        </p:nvSpPr>
        <p:spPr>
          <a:xfrm>
            <a:off x="6951216" y="5192578"/>
            <a:ext cx="6912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A-1155463</a:t>
            </a:r>
            <a:endParaRPr lang="fi-FI" sz="9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FD49F1C-2829-4A39-98DE-97477219F5DF}"/>
              </a:ext>
            </a:extLst>
          </p:cNvPr>
          <p:cNvSpPr txBox="1"/>
          <p:nvPr/>
        </p:nvSpPr>
        <p:spPr>
          <a:xfrm>
            <a:off x="6978623" y="5022196"/>
            <a:ext cx="4700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4NQO</a:t>
            </a:r>
            <a:endParaRPr lang="fi-FI" sz="9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6079E3D-B7F4-4BDB-8389-57815937B3EF}"/>
              </a:ext>
            </a:extLst>
          </p:cNvPr>
          <p:cNvSpPr txBox="1"/>
          <p:nvPr/>
        </p:nvSpPr>
        <p:spPr>
          <a:xfrm>
            <a:off x="4573690" y="49819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37010C-F298-48C8-957C-7177BC533465}"/>
              </a:ext>
            </a:extLst>
          </p:cNvPr>
          <p:cNvSpPr txBox="1"/>
          <p:nvPr/>
        </p:nvSpPr>
        <p:spPr>
          <a:xfrm>
            <a:off x="4944689" y="49819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1CC58B8-E9FD-405D-B34C-DDFBB6606825}"/>
              </a:ext>
            </a:extLst>
          </p:cNvPr>
          <p:cNvSpPr txBox="1"/>
          <p:nvPr/>
        </p:nvSpPr>
        <p:spPr>
          <a:xfrm>
            <a:off x="4946983" y="5103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64D78AA-1402-47FE-9D3C-B55459040DB0}"/>
              </a:ext>
            </a:extLst>
          </p:cNvPr>
          <p:cNvSpPr txBox="1"/>
          <p:nvPr/>
        </p:nvSpPr>
        <p:spPr>
          <a:xfrm>
            <a:off x="4732687" y="510544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1A6437-05B6-4CB0-BFE4-7C92481D043D}"/>
              </a:ext>
            </a:extLst>
          </p:cNvPr>
          <p:cNvSpPr txBox="1"/>
          <p:nvPr/>
        </p:nvSpPr>
        <p:spPr>
          <a:xfrm>
            <a:off x="5418256" y="497391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CF4F2E-E754-425A-93E4-DED2C510FF5E}"/>
              </a:ext>
            </a:extLst>
          </p:cNvPr>
          <p:cNvSpPr txBox="1"/>
          <p:nvPr/>
        </p:nvSpPr>
        <p:spPr>
          <a:xfrm>
            <a:off x="5789255" y="497391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970C359-45B9-441E-837E-6CE1CA1D07A6}"/>
              </a:ext>
            </a:extLst>
          </p:cNvPr>
          <p:cNvSpPr txBox="1"/>
          <p:nvPr/>
        </p:nvSpPr>
        <p:spPr>
          <a:xfrm>
            <a:off x="5791549" y="509553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AE52087-2845-4708-A9CD-67948642DD0A}"/>
              </a:ext>
            </a:extLst>
          </p:cNvPr>
          <p:cNvSpPr txBox="1"/>
          <p:nvPr/>
        </p:nvSpPr>
        <p:spPr>
          <a:xfrm>
            <a:off x="5577253" y="509737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983B8D6-A525-47D3-AAD0-2251E3B20404}"/>
              </a:ext>
            </a:extLst>
          </p:cNvPr>
          <p:cNvSpPr txBox="1"/>
          <p:nvPr/>
        </p:nvSpPr>
        <p:spPr>
          <a:xfrm>
            <a:off x="6266447" y="499424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CD3F582-76A4-46D4-8224-3344EFDF10D2}"/>
              </a:ext>
            </a:extLst>
          </p:cNvPr>
          <p:cNvSpPr txBox="1"/>
          <p:nvPr/>
        </p:nvSpPr>
        <p:spPr>
          <a:xfrm>
            <a:off x="6637446" y="499424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08CF2E9-F57A-4740-99D3-15D629D5D135}"/>
              </a:ext>
            </a:extLst>
          </p:cNvPr>
          <p:cNvSpPr txBox="1"/>
          <p:nvPr/>
        </p:nvSpPr>
        <p:spPr>
          <a:xfrm>
            <a:off x="6639740" y="51158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0588A15-FA34-43B6-8BC2-58C5CA12238F}"/>
              </a:ext>
            </a:extLst>
          </p:cNvPr>
          <p:cNvSpPr txBox="1"/>
          <p:nvPr/>
        </p:nvSpPr>
        <p:spPr>
          <a:xfrm>
            <a:off x="6425444" y="51177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1200" dirty="0"/>
              <a:t>+</a:t>
            </a:r>
            <a:endParaRPr lang="nb-NO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6D5D6E-98CB-408B-B65F-4B20F793F945}"/>
              </a:ext>
            </a:extLst>
          </p:cNvPr>
          <p:cNvSpPr txBox="1"/>
          <p:nvPr/>
        </p:nvSpPr>
        <p:spPr>
          <a:xfrm>
            <a:off x="1406926" y="560970"/>
            <a:ext cx="14189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3600" b="1" dirty="0"/>
              <a:t>Fig. 4a</a:t>
            </a:r>
            <a:endParaRPr lang="nb-NO" sz="3600" b="1" dirty="0"/>
          </a:p>
        </p:txBody>
      </p:sp>
      <p:pic>
        <p:nvPicPr>
          <p:cNvPr id="33" name="Picture 2">
            <a:extLst>
              <a:ext uri="{FF2B5EF4-FFF2-40B4-BE49-F238E27FC236}">
                <a16:creationId xmlns:a16="http://schemas.microsoft.com/office/drawing/2014/main" id="{E6FD3DA8-43EA-454C-B1F8-D6BCDC51D53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383" b="32970"/>
          <a:stretch/>
        </p:blipFill>
        <p:spPr bwMode="auto">
          <a:xfrm>
            <a:off x="3968921" y="4450180"/>
            <a:ext cx="3057462" cy="524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401FE9AD-8C8E-4935-9D60-4418ADFBDC91}"/>
              </a:ext>
            </a:extLst>
          </p:cNvPr>
          <p:cNvSpPr txBox="1"/>
          <p:nvPr/>
        </p:nvSpPr>
        <p:spPr>
          <a:xfrm>
            <a:off x="6996684" y="4538668"/>
            <a:ext cx="4299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AXX</a:t>
            </a:r>
          </a:p>
        </p:txBody>
      </p:sp>
      <p:pic>
        <p:nvPicPr>
          <p:cNvPr id="35" name="Picture 2">
            <a:extLst>
              <a:ext uri="{FF2B5EF4-FFF2-40B4-BE49-F238E27FC236}">
                <a16:creationId xmlns:a16="http://schemas.microsoft.com/office/drawing/2014/main" id="{A3F162B8-1D89-434A-91EF-7688DF4CA4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479" b="6390"/>
          <a:stretch/>
        </p:blipFill>
        <p:spPr bwMode="auto">
          <a:xfrm>
            <a:off x="3935762" y="3287098"/>
            <a:ext cx="3090622" cy="5246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18C07420-8344-418C-856C-3E814EAFD4D1}"/>
              </a:ext>
            </a:extLst>
          </p:cNvPr>
          <p:cNvSpPr txBox="1"/>
          <p:nvPr/>
        </p:nvSpPr>
        <p:spPr>
          <a:xfrm>
            <a:off x="6948594" y="3464705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900" dirty="0"/>
              <a:t>B</a:t>
            </a:r>
            <a:r>
              <a:rPr lang="nb-NO" sz="900" dirty="0" err="1"/>
              <a:t>ax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9367331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3013" y="627632"/>
            <a:ext cx="10515600" cy="1325563"/>
          </a:xfrm>
        </p:spPr>
        <p:txBody>
          <a:bodyPr/>
          <a:lstStyle/>
          <a:p>
            <a:r>
              <a:rPr lang="en-US" dirty="0"/>
              <a:t>P53, GAPDH, </a:t>
            </a:r>
            <a:r>
              <a:rPr lang="en-US" dirty="0" err="1"/>
              <a:t>Bcl-xL</a:t>
            </a:r>
            <a:endParaRPr lang="fi-FI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83"/>
          <a:stretch/>
        </p:blipFill>
        <p:spPr>
          <a:xfrm>
            <a:off x="3462728" y="1690688"/>
            <a:ext cx="3716260" cy="3489447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 flipH="1">
            <a:off x="7101455" y="3105349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464049" y="2655990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53</a:t>
            </a:r>
            <a:endParaRPr lang="fi-FI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38E672DC-4D93-471C-BC9D-1339D7B1BDE7}"/>
              </a:ext>
            </a:extLst>
          </p:cNvPr>
          <p:cNvCxnSpPr/>
          <p:nvPr/>
        </p:nvCxnSpPr>
        <p:spPr>
          <a:xfrm flipH="1">
            <a:off x="7101455" y="2840656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51CEF84-415B-4DE3-990E-E1A5CDA7415B}"/>
              </a:ext>
            </a:extLst>
          </p:cNvPr>
          <p:cNvSpPr txBox="1"/>
          <p:nvPr/>
        </p:nvSpPr>
        <p:spPr>
          <a:xfrm>
            <a:off x="7464050" y="291266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  <a:endParaRPr lang="fi-FI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81796BA-C5C0-48E6-A173-E5C4E3F378EF}"/>
              </a:ext>
            </a:extLst>
          </p:cNvPr>
          <p:cNvCxnSpPr/>
          <p:nvPr/>
        </p:nvCxnSpPr>
        <p:spPr>
          <a:xfrm flipH="1">
            <a:off x="7131116" y="3402840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07CE0C8-5774-46F0-A891-4B7D6DC798E6}"/>
              </a:ext>
            </a:extLst>
          </p:cNvPr>
          <p:cNvSpPr txBox="1"/>
          <p:nvPr/>
        </p:nvSpPr>
        <p:spPr>
          <a:xfrm>
            <a:off x="7493710" y="3218174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Bcl</a:t>
            </a:r>
            <a:r>
              <a:rPr lang="en-US" dirty="0"/>
              <a:t>-XL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39116236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577065"/>
            <a:ext cx="10515600" cy="1325563"/>
          </a:xfrm>
        </p:spPr>
        <p:txBody>
          <a:bodyPr/>
          <a:lstStyle/>
          <a:p>
            <a:r>
              <a:rPr lang="fi-FI" dirty="0" err="1"/>
              <a:t>antiBAD</a:t>
            </a:r>
            <a:endParaRPr lang="fi-FI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5"/>
          <a:stretch/>
        </p:blipFill>
        <p:spPr>
          <a:xfrm>
            <a:off x="3792511" y="1929540"/>
            <a:ext cx="3223547" cy="3099816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>
            <a:off x="6905618" y="3325662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7268212" y="3140996"/>
            <a:ext cx="583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AD</a:t>
            </a:r>
            <a:endParaRPr lang="fi-FI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AD793AD-CD94-490F-AE7F-633915D700F9}"/>
              </a:ext>
            </a:extLst>
          </p:cNvPr>
          <p:cNvCxnSpPr/>
          <p:nvPr/>
        </p:nvCxnSpPr>
        <p:spPr>
          <a:xfrm flipH="1">
            <a:off x="6922570" y="3114084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010476A-BA10-4752-A901-8FF9D11C61BD}"/>
              </a:ext>
            </a:extLst>
          </p:cNvPr>
          <p:cNvSpPr txBox="1"/>
          <p:nvPr/>
        </p:nvSpPr>
        <p:spPr>
          <a:xfrm>
            <a:off x="7285164" y="2929418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Bcl</a:t>
            </a:r>
            <a:r>
              <a:rPr lang="en-US" dirty="0"/>
              <a:t>-XL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28200040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858640"/>
            <a:ext cx="10515600" cy="1325563"/>
          </a:xfrm>
        </p:spPr>
        <p:txBody>
          <a:bodyPr/>
          <a:lstStyle/>
          <a:p>
            <a:r>
              <a:rPr lang="fi-FI" dirty="0" err="1"/>
              <a:t>antiBAX</a:t>
            </a:r>
            <a:r>
              <a:rPr lang="fi-FI" dirty="0"/>
              <a:t>(</a:t>
            </a:r>
            <a:r>
              <a:rPr lang="fi-FI" dirty="0" err="1"/>
              <a:t>Rab</a:t>
            </a:r>
            <a:r>
              <a:rPr lang="fi-FI" dirty="0"/>
              <a:t>)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45" r="9215" b="26275"/>
          <a:stretch/>
        </p:blipFill>
        <p:spPr>
          <a:xfrm>
            <a:off x="3882452" y="2184203"/>
            <a:ext cx="3090537" cy="2321301"/>
          </a:xfrm>
          <a:prstGeom prst="rect">
            <a:avLst/>
          </a:prstGeom>
        </p:spPr>
      </p:pic>
      <p:cxnSp>
        <p:nvCxnSpPr>
          <p:cNvPr id="9" name="Straight Arrow Connector 8"/>
          <p:cNvCxnSpPr/>
          <p:nvPr/>
        </p:nvCxnSpPr>
        <p:spPr>
          <a:xfrm flipH="1">
            <a:off x="6972989" y="4182443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7335583" y="3997777"/>
            <a:ext cx="560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X</a:t>
            </a:r>
            <a:endParaRPr lang="fi-FI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8183F52-3120-4941-B02D-09BF20933975}"/>
              </a:ext>
            </a:extLst>
          </p:cNvPr>
          <p:cNvCxnSpPr/>
          <p:nvPr/>
        </p:nvCxnSpPr>
        <p:spPr>
          <a:xfrm flipH="1">
            <a:off x="7042885" y="3852016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B643991-F605-469A-B053-BF58B5DEEAEF}"/>
              </a:ext>
            </a:extLst>
          </p:cNvPr>
          <p:cNvSpPr txBox="1"/>
          <p:nvPr/>
        </p:nvSpPr>
        <p:spPr>
          <a:xfrm>
            <a:off x="7405479" y="366735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Bcl</a:t>
            </a:r>
            <a:r>
              <a:rPr lang="en-US" dirty="0"/>
              <a:t>-XL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33866232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5979F-3FDC-4A2E-8FB9-A1548106D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6046" y="95438"/>
            <a:ext cx="10515600" cy="1325563"/>
          </a:xfrm>
        </p:spPr>
        <p:txBody>
          <a:bodyPr/>
          <a:lstStyle/>
          <a:p>
            <a:r>
              <a:rPr lang="fi-FI" dirty="0"/>
              <a:t>Fig. 5a</a:t>
            </a:r>
            <a:endParaRPr lang="nb-NO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C343C545-B494-4D89-B5CA-39BB3FC10B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267" t="18687" r="13061" b="53277"/>
          <a:stretch/>
        </p:blipFill>
        <p:spPr>
          <a:xfrm>
            <a:off x="3490424" y="2033061"/>
            <a:ext cx="4804686" cy="16150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8D1AC91-CACC-4729-BED4-FC47DBD8763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330" t="-1" r="6823" b="69811"/>
          <a:stretch/>
        </p:blipFill>
        <p:spPr>
          <a:xfrm flipH="1">
            <a:off x="3490424" y="3700790"/>
            <a:ext cx="4804686" cy="16627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1C75161-8442-451C-BD9C-86CF9A1B1727}"/>
              </a:ext>
            </a:extLst>
          </p:cNvPr>
          <p:cNvSpPr txBox="1"/>
          <p:nvPr/>
        </p:nvSpPr>
        <p:spPr>
          <a:xfrm>
            <a:off x="8295110" y="4054144"/>
            <a:ext cx="1117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APDH</a:t>
            </a:r>
            <a:endParaRPr lang="fi-FI"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6E0C3E-6AFA-40FC-A15C-A9E133760DD1}"/>
              </a:ext>
            </a:extLst>
          </p:cNvPr>
          <p:cNvSpPr txBox="1"/>
          <p:nvPr/>
        </p:nvSpPr>
        <p:spPr>
          <a:xfrm>
            <a:off x="8295110" y="2352130"/>
            <a:ext cx="6607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p53</a:t>
            </a:r>
            <a:endParaRPr lang="fi-FI" sz="2400" b="1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7919E6C-DFB6-4D89-902F-AE8FAEC15023}"/>
              </a:ext>
            </a:extLst>
          </p:cNvPr>
          <p:cNvSpPr/>
          <p:nvPr/>
        </p:nvSpPr>
        <p:spPr>
          <a:xfrm>
            <a:off x="6540499" y="916729"/>
            <a:ext cx="10246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-/-</a:t>
            </a:r>
            <a:endParaRPr lang="en-GB" sz="2400" b="1" u="sng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5D307B-D24F-484F-B3B4-F62C363F40E4}"/>
              </a:ext>
            </a:extLst>
          </p:cNvPr>
          <p:cNvSpPr/>
          <p:nvPr/>
        </p:nvSpPr>
        <p:spPr>
          <a:xfrm>
            <a:off x="4372150" y="916729"/>
            <a:ext cx="11047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+/+</a:t>
            </a:r>
            <a:endParaRPr lang="en-GB" sz="2400" b="1" u="sng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693021-B420-4E35-BE3A-35C08DF899B3}"/>
              </a:ext>
            </a:extLst>
          </p:cNvPr>
          <p:cNvSpPr txBox="1"/>
          <p:nvPr/>
        </p:nvSpPr>
        <p:spPr>
          <a:xfrm>
            <a:off x="8170076" y="1695103"/>
            <a:ext cx="9108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4-NQO</a:t>
            </a:r>
            <a:endParaRPr lang="fi-FI" sz="2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DB0C83-83F4-48E8-AA71-EA4054781B50}"/>
              </a:ext>
            </a:extLst>
          </p:cNvPr>
          <p:cNvSpPr txBox="1"/>
          <p:nvPr/>
        </p:nvSpPr>
        <p:spPr>
          <a:xfrm>
            <a:off x="8170076" y="1399335"/>
            <a:ext cx="1321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-1155463</a:t>
            </a:r>
            <a:endParaRPr lang="fi-FI" sz="2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9888D7-C8F7-4261-ACA8-9FEE252E8F47}"/>
              </a:ext>
            </a:extLst>
          </p:cNvPr>
          <p:cNvSpPr txBox="1"/>
          <p:nvPr/>
        </p:nvSpPr>
        <p:spPr>
          <a:xfrm>
            <a:off x="3977363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ADB8653-0C27-4FD6-8132-333D1817B6F5}"/>
              </a:ext>
            </a:extLst>
          </p:cNvPr>
          <p:cNvSpPr txBox="1"/>
          <p:nvPr/>
        </p:nvSpPr>
        <p:spPr>
          <a:xfrm>
            <a:off x="4471808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3057E06-3323-45EB-B223-A01FE973B63A}"/>
              </a:ext>
            </a:extLst>
          </p:cNvPr>
          <p:cNvSpPr txBox="1"/>
          <p:nvPr/>
        </p:nvSpPr>
        <p:spPr>
          <a:xfrm>
            <a:off x="553384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CE34FD7-B9C9-4379-9738-9C1ABAC3558D}"/>
              </a:ext>
            </a:extLst>
          </p:cNvPr>
          <p:cNvSpPr txBox="1"/>
          <p:nvPr/>
        </p:nvSpPr>
        <p:spPr>
          <a:xfrm>
            <a:off x="6467739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2166D16-F0AB-4807-BDE2-676C0428FF7E}"/>
              </a:ext>
            </a:extLst>
          </p:cNvPr>
          <p:cNvSpPr txBox="1"/>
          <p:nvPr/>
        </p:nvSpPr>
        <p:spPr>
          <a:xfrm>
            <a:off x="746948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1783C92-4663-410C-BA07-2692806B854A}"/>
              </a:ext>
            </a:extLst>
          </p:cNvPr>
          <p:cNvSpPr txBox="1"/>
          <p:nvPr/>
        </p:nvSpPr>
        <p:spPr>
          <a:xfrm>
            <a:off x="5040791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F7D634-A83F-4A88-8CEE-35AE37C3700D}"/>
              </a:ext>
            </a:extLst>
          </p:cNvPr>
          <p:cNvSpPr txBox="1"/>
          <p:nvPr/>
        </p:nvSpPr>
        <p:spPr>
          <a:xfrm>
            <a:off x="6025638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3DE005D-5E72-4D14-9F86-F8FAA55AE2B9}"/>
              </a:ext>
            </a:extLst>
          </p:cNvPr>
          <p:cNvSpPr txBox="1"/>
          <p:nvPr/>
        </p:nvSpPr>
        <p:spPr>
          <a:xfrm>
            <a:off x="6959532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0710A5-BFDC-430C-8B37-E299C4770566}"/>
              </a:ext>
            </a:extLst>
          </p:cNvPr>
          <p:cNvSpPr txBox="1"/>
          <p:nvPr/>
        </p:nvSpPr>
        <p:spPr>
          <a:xfrm>
            <a:off x="7469486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33EA4CD-1EB1-410F-9518-32CBEC66BEE1}"/>
              </a:ext>
            </a:extLst>
          </p:cNvPr>
          <p:cNvSpPr txBox="1"/>
          <p:nvPr/>
        </p:nvSpPr>
        <p:spPr>
          <a:xfrm>
            <a:off x="6939326" y="1379460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BDDE333-4141-4B2E-8083-E6FAF99DD5DD}"/>
              </a:ext>
            </a:extLst>
          </p:cNvPr>
          <p:cNvSpPr txBox="1"/>
          <p:nvPr/>
        </p:nvSpPr>
        <p:spPr>
          <a:xfrm>
            <a:off x="5533847" y="138146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B957FF6-7C3A-45FE-91C9-5781C5CDECF7}"/>
              </a:ext>
            </a:extLst>
          </p:cNvPr>
          <p:cNvSpPr txBox="1"/>
          <p:nvPr/>
        </p:nvSpPr>
        <p:spPr>
          <a:xfrm>
            <a:off x="5017639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2102AEB-85C7-44F2-952F-C918AF4782F3}"/>
              </a:ext>
            </a:extLst>
          </p:cNvPr>
          <p:cNvSpPr txBox="1"/>
          <p:nvPr/>
        </p:nvSpPr>
        <p:spPr>
          <a:xfrm>
            <a:off x="604038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4B816E6-4C0C-44AF-9DAA-99616172CECE}"/>
              </a:ext>
            </a:extLst>
          </p:cNvPr>
          <p:cNvSpPr txBox="1"/>
          <p:nvPr/>
        </p:nvSpPr>
        <p:spPr>
          <a:xfrm>
            <a:off x="6488253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DCFF4E5-79BC-4B8E-837C-A94DC3CA89E1}"/>
              </a:ext>
            </a:extLst>
          </p:cNvPr>
          <p:cNvSpPr txBox="1"/>
          <p:nvPr/>
        </p:nvSpPr>
        <p:spPr>
          <a:xfrm>
            <a:off x="449936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14A6B6A-00CF-42FB-82E0-D9AD7519FF98}"/>
              </a:ext>
            </a:extLst>
          </p:cNvPr>
          <p:cNvSpPr txBox="1"/>
          <p:nvPr/>
        </p:nvSpPr>
        <p:spPr>
          <a:xfrm>
            <a:off x="3977985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</p:spTree>
    <p:extLst>
      <p:ext uri="{BB962C8B-B14F-4D97-AF65-F5344CB8AC3E}">
        <p14:creationId xmlns:p14="http://schemas.microsoft.com/office/powerpoint/2010/main" val="33570704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8A3918BE-A622-4F74-8381-0BDF6648C65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3" t="439" r="-175" b="41402"/>
          <a:stretch/>
        </p:blipFill>
        <p:spPr>
          <a:xfrm>
            <a:off x="2076137" y="981856"/>
            <a:ext cx="7172793" cy="335030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2E57977-8049-4633-8175-9B68A6FB3175}"/>
              </a:ext>
            </a:extLst>
          </p:cNvPr>
          <p:cNvSpPr txBox="1"/>
          <p:nvPr/>
        </p:nvSpPr>
        <p:spPr>
          <a:xfrm>
            <a:off x="8295110" y="2352130"/>
            <a:ext cx="6607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p53</a:t>
            </a:r>
            <a:endParaRPr lang="fi-FI" sz="2400" b="1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483CB16-A936-4F01-8826-6638FF706645}"/>
              </a:ext>
            </a:extLst>
          </p:cNvPr>
          <p:cNvSpPr/>
          <p:nvPr/>
        </p:nvSpPr>
        <p:spPr>
          <a:xfrm>
            <a:off x="6540499" y="916729"/>
            <a:ext cx="10246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-/-</a:t>
            </a:r>
            <a:endParaRPr lang="en-GB" sz="2400" b="1" u="sng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513DFBF-6011-4A61-A210-107F5A4C49AA}"/>
              </a:ext>
            </a:extLst>
          </p:cNvPr>
          <p:cNvSpPr/>
          <p:nvPr/>
        </p:nvSpPr>
        <p:spPr>
          <a:xfrm>
            <a:off x="4372150" y="916729"/>
            <a:ext cx="11047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+/+</a:t>
            </a:r>
            <a:endParaRPr lang="en-GB" sz="2400" b="1" u="sng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23158E-4FD7-4DFD-8246-686FC0EEECBE}"/>
              </a:ext>
            </a:extLst>
          </p:cNvPr>
          <p:cNvSpPr txBox="1"/>
          <p:nvPr/>
        </p:nvSpPr>
        <p:spPr>
          <a:xfrm>
            <a:off x="8170076" y="1695103"/>
            <a:ext cx="9108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4-NQO</a:t>
            </a:r>
            <a:endParaRPr lang="fi-FI" sz="2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53711CD-79B1-48F8-9735-79E441E78704}"/>
              </a:ext>
            </a:extLst>
          </p:cNvPr>
          <p:cNvSpPr txBox="1"/>
          <p:nvPr/>
        </p:nvSpPr>
        <p:spPr>
          <a:xfrm>
            <a:off x="8170076" y="1399335"/>
            <a:ext cx="1321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-1155463</a:t>
            </a:r>
            <a:endParaRPr lang="fi-FI" sz="2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A95E20-693E-47FD-9D63-5654FE5FB62B}"/>
              </a:ext>
            </a:extLst>
          </p:cNvPr>
          <p:cNvSpPr txBox="1"/>
          <p:nvPr/>
        </p:nvSpPr>
        <p:spPr>
          <a:xfrm>
            <a:off x="3977363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DC82090-6BAB-4E5B-B663-30181E320B91}"/>
              </a:ext>
            </a:extLst>
          </p:cNvPr>
          <p:cNvSpPr txBox="1"/>
          <p:nvPr/>
        </p:nvSpPr>
        <p:spPr>
          <a:xfrm>
            <a:off x="4471808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11611A-789F-4521-B0EA-42C78F111A7D}"/>
              </a:ext>
            </a:extLst>
          </p:cNvPr>
          <p:cNvSpPr txBox="1"/>
          <p:nvPr/>
        </p:nvSpPr>
        <p:spPr>
          <a:xfrm>
            <a:off x="553384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988D109-4E1D-4829-AF6A-73627A5B17E2}"/>
              </a:ext>
            </a:extLst>
          </p:cNvPr>
          <p:cNvSpPr txBox="1"/>
          <p:nvPr/>
        </p:nvSpPr>
        <p:spPr>
          <a:xfrm>
            <a:off x="6467739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BEE416-8F06-46AF-8F9D-3C0F74FB374A}"/>
              </a:ext>
            </a:extLst>
          </p:cNvPr>
          <p:cNvSpPr txBox="1"/>
          <p:nvPr/>
        </p:nvSpPr>
        <p:spPr>
          <a:xfrm>
            <a:off x="746948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6CE48CD-14F9-47A9-91EB-DF60BCBD27BC}"/>
              </a:ext>
            </a:extLst>
          </p:cNvPr>
          <p:cNvSpPr txBox="1"/>
          <p:nvPr/>
        </p:nvSpPr>
        <p:spPr>
          <a:xfrm>
            <a:off x="5040791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4CD22DE-7FA3-4ED7-B58C-B2EB065D29C1}"/>
              </a:ext>
            </a:extLst>
          </p:cNvPr>
          <p:cNvSpPr txBox="1"/>
          <p:nvPr/>
        </p:nvSpPr>
        <p:spPr>
          <a:xfrm>
            <a:off x="6025638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4B08812-76CE-4F66-8ACA-096F6B4D7223}"/>
              </a:ext>
            </a:extLst>
          </p:cNvPr>
          <p:cNvSpPr txBox="1"/>
          <p:nvPr/>
        </p:nvSpPr>
        <p:spPr>
          <a:xfrm>
            <a:off x="6959532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14F2E50-899D-4471-B76F-1C96D42AC4B6}"/>
              </a:ext>
            </a:extLst>
          </p:cNvPr>
          <p:cNvSpPr txBox="1"/>
          <p:nvPr/>
        </p:nvSpPr>
        <p:spPr>
          <a:xfrm>
            <a:off x="7469486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D1C9B79-7980-416E-94FC-6494B56520EC}"/>
              </a:ext>
            </a:extLst>
          </p:cNvPr>
          <p:cNvSpPr txBox="1"/>
          <p:nvPr/>
        </p:nvSpPr>
        <p:spPr>
          <a:xfrm>
            <a:off x="6939326" y="1379460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9DEE482-D908-487E-B7CA-288C5CF6CAF3}"/>
              </a:ext>
            </a:extLst>
          </p:cNvPr>
          <p:cNvSpPr txBox="1"/>
          <p:nvPr/>
        </p:nvSpPr>
        <p:spPr>
          <a:xfrm>
            <a:off x="5533847" y="138146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0F3A730-5CE7-42BD-8ED1-110598AA1741}"/>
              </a:ext>
            </a:extLst>
          </p:cNvPr>
          <p:cNvSpPr txBox="1"/>
          <p:nvPr/>
        </p:nvSpPr>
        <p:spPr>
          <a:xfrm>
            <a:off x="5017639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390A8AB-BE3A-4A81-B2BF-7C196F080203}"/>
              </a:ext>
            </a:extLst>
          </p:cNvPr>
          <p:cNvSpPr txBox="1"/>
          <p:nvPr/>
        </p:nvSpPr>
        <p:spPr>
          <a:xfrm>
            <a:off x="604038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0ABD21-E97F-4521-A240-483A8ED52CB8}"/>
              </a:ext>
            </a:extLst>
          </p:cNvPr>
          <p:cNvSpPr txBox="1"/>
          <p:nvPr/>
        </p:nvSpPr>
        <p:spPr>
          <a:xfrm>
            <a:off x="6488253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8BE4D70-72FC-4634-9E4A-9965F66F6B1C}"/>
              </a:ext>
            </a:extLst>
          </p:cNvPr>
          <p:cNvSpPr txBox="1"/>
          <p:nvPr/>
        </p:nvSpPr>
        <p:spPr>
          <a:xfrm>
            <a:off x="449936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ECF4C6-DC05-440E-8DD5-5DD91B792170}"/>
              </a:ext>
            </a:extLst>
          </p:cNvPr>
          <p:cNvSpPr txBox="1"/>
          <p:nvPr/>
        </p:nvSpPr>
        <p:spPr>
          <a:xfrm>
            <a:off x="3977985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</p:spTree>
    <p:extLst>
      <p:ext uri="{BB962C8B-B14F-4D97-AF65-F5344CB8AC3E}">
        <p14:creationId xmlns:p14="http://schemas.microsoft.com/office/powerpoint/2010/main" val="29007231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FD5A01-BB46-4151-8B0F-7DD5B8F4A1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342" t="-104" r="-117" b="38183"/>
          <a:stretch/>
        </p:blipFill>
        <p:spPr>
          <a:xfrm flipH="1">
            <a:off x="2848362" y="2240169"/>
            <a:ext cx="6910465" cy="34102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434181-F68F-43F4-8331-255E51AEA720}"/>
              </a:ext>
            </a:extLst>
          </p:cNvPr>
          <p:cNvSpPr txBox="1"/>
          <p:nvPr/>
        </p:nvSpPr>
        <p:spPr>
          <a:xfrm>
            <a:off x="8130450" y="2599238"/>
            <a:ext cx="1117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GAPDH</a:t>
            </a:r>
            <a:endParaRPr lang="fi-FI" sz="2400" b="1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4104320-8318-4D96-8DC5-0A9141722F8E}"/>
              </a:ext>
            </a:extLst>
          </p:cNvPr>
          <p:cNvSpPr/>
          <p:nvPr/>
        </p:nvSpPr>
        <p:spPr>
          <a:xfrm>
            <a:off x="6540499" y="916729"/>
            <a:ext cx="102463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-/-</a:t>
            </a:r>
            <a:endParaRPr lang="en-GB" sz="2400" b="1" u="sng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230815-4DE2-477E-917A-3547A2BD40E3}"/>
              </a:ext>
            </a:extLst>
          </p:cNvPr>
          <p:cNvSpPr/>
          <p:nvPr/>
        </p:nvSpPr>
        <p:spPr>
          <a:xfrm>
            <a:off x="4372150" y="916729"/>
            <a:ext cx="11047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i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TP</a:t>
            </a:r>
            <a:r>
              <a:rPr lang="en-US" sz="2400" b="1" u="sng" dirty="0">
                <a:solidFill>
                  <a:srgbClr val="000000"/>
                </a:solidFill>
                <a:ea typeface="Times New Roman" panose="02020603050405020304" pitchFamily="18" charset="0"/>
              </a:rPr>
              <a:t>53</a:t>
            </a:r>
            <a:r>
              <a:rPr lang="en-US" sz="2400" b="1" u="sng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+/+</a:t>
            </a:r>
            <a:endParaRPr lang="en-GB" sz="2400" b="1" u="sng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582C03-C5B2-44B1-8EB9-7AE4CEEA8E8B}"/>
              </a:ext>
            </a:extLst>
          </p:cNvPr>
          <p:cNvSpPr txBox="1"/>
          <p:nvPr/>
        </p:nvSpPr>
        <p:spPr>
          <a:xfrm>
            <a:off x="8170076" y="1695103"/>
            <a:ext cx="9108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4-NQO</a:t>
            </a:r>
            <a:endParaRPr lang="fi-FI" sz="2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45856E3-4058-4E9C-B760-22EEFD702A80}"/>
              </a:ext>
            </a:extLst>
          </p:cNvPr>
          <p:cNvSpPr txBox="1"/>
          <p:nvPr/>
        </p:nvSpPr>
        <p:spPr>
          <a:xfrm>
            <a:off x="8170076" y="1399335"/>
            <a:ext cx="1321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-1155463</a:t>
            </a:r>
            <a:endParaRPr lang="fi-FI" sz="2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710C6FB-532D-4059-BDDA-DCF24B658385}"/>
              </a:ext>
            </a:extLst>
          </p:cNvPr>
          <p:cNvSpPr txBox="1"/>
          <p:nvPr/>
        </p:nvSpPr>
        <p:spPr>
          <a:xfrm>
            <a:off x="3977363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3FFD5B-E39D-481C-A09D-38614E93B9B3}"/>
              </a:ext>
            </a:extLst>
          </p:cNvPr>
          <p:cNvSpPr txBox="1"/>
          <p:nvPr/>
        </p:nvSpPr>
        <p:spPr>
          <a:xfrm>
            <a:off x="4471808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8010F65-523E-411B-9B39-FD17651CD944}"/>
              </a:ext>
            </a:extLst>
          </p:cNvPr>
          <p:cNvSpPr txBox="1"/>
          <p:nvPr/>
        </p:nvSpPr>
        <p:spPr>
          <a:xfrm>
            <a:off x="553384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F2C6F23-C969-4212-8A95-B13518035AC2}"/>
              </a:ext>
            </a:extLst>
          </p:cNvPr>
          <p:cNvSpPr txBox="1"/>
          <p:nvPr/>
        </p:nvSpPr>
        <p:spPr>
          <a:xfrm>
            <a:off x="6467739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C629353-1170-4269-ACEE-572A255743ED}"/>
              </a:ext>
            </a:extLst>
          </p:cNvPr>
          <p:cNvSpPr txBox="1"/>
          <p:nvPr/>
        </p:nvSpPr>
        <p:spPr>
          <a:xfrm>
            <a:off x="7469486" y="167416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B0E77B-07AD-4ED4-AB7E-D3E2A42049E8}"/>
              </a:ext>
            </a:extLst>
          </p:cNvPr>
          <p:cNvSpPr txBox="1"/>
          <p:nvPr/>
        </p:nvSpPr>
        <p:spPr>
          <a:xfrm>
            <a:off x="5040791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BA7BEE-F7C2-4892-B934-E8BBAB4F7950}"/>
              </a:ext>
            </a:extLst>
          </p:cNvPr>
          <p:cNvSpPr txBox="1"/>
          <p:nvPr/>
        </p:nvSpPr>
        <p:spPr>
          <a:xfrm>
            <a:off x="6025638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EB88DB5-CEE5-450B-A00F-9E4411DDF4C8}"/>
              </a:ext>
            </a:extLst>
          </p:cNvPr>
          <p:cNvSpPr txBox="1"/>
          <p:nvPr/>
        </p:nvSpPr>
        <p:spPr>
          <a:xfrm>
            <a:off x="6959532" y="1674162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D49D59-371E-4B55-849E-C88E9677DEC0}"/>
              </a:ext>
            </a:extLst>
          </p:cNvPr>
          <p:cNvSpPr txBox="1"/>
          <p:nvPr/>
        </p:nvSpPr>
        <p:spPr>
          <a:xfrm>
            <a:off x="7469486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8C3C05-C0F2-4767-80E2-FE1E7DB77348}"/>
              </a:ext>
            </a:extLst>
          </p:cNvPr>
          <p:cNvSpPr txBox="1"/>
          <p:nvPr/>
        </p:nvSpPr>
        <p:spPr>
          <a:xfrm>
            <a:off x="6939326" y="1379460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9DFDBBA-0E56-4373-9A16-EF0B99F868E0}"/>
              </a:ext>
            </a:extLst>
          </p:cNvPr>
          <p:cNvSpPr txBox="1"/>
          <p:nvPr/>
        </p:nvSpPr>
        <p:spPr>
          <a:xfrm>
            <a:off x="5533847" y="138146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D154460-A44F-43A4-B8DA-8F7634FA9505}"/>
              </a:ext>
            </a:extLst>
          </p:cNvPr>
          <p:cNvSpPr txBox="1"/>
          <p:nvPr/>
        </p:nvSpPr>
        <p:spPr>
          <a:xfrm>
            <a:off x="5017639" y="1378394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+</a:t>
            </a:r>
            <a:endParaRPr lang="fi-FI" sz="2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14AFBDE-EC48-44C1-B918-801CD15C14F4}"/>
              </a:ext>
            </a:extLst>
          </p:cNvPr>
          <p:cNvSpPr txBox="1"/>
          <p:nvPr/>
        </p:nvSpPr>
        <p:spPr>
          <a:xfrm>
            <a:off x="604038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0EBAA1A-5152-4B0C-A3D2-E85CDCC62720}"/>
              </a:ext>
            </a:extLst>
          </p:cNvPr>
          <p:cNvSpPr txBox="1"/>
          <p:nvPr/>
        </p:nvSpPr>
        <p:spPr>
          <a:xfrm>
            <a:off x="6488253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7F645BA-8E44-40D1-BE9A-55C128E8B28C}"/>
              </a:ext>
            </a:extLst>
          </p:cNvPr>
          <p:cNvSpPr txBox="1"/>
          <p:nvPr/>
        </p:nvSpPr>
        <p:spPr>
          <a:xfrm>
            <a:off x="4499361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6162C42-6833-4D02-BD9D-388E59798FFA}"/>
              </a:ext>
            </a:extLst>
          </p:cNvPr>
          <p:cNvSpPr txBox="1"/>
          <p:nvPr/>
        </p:nvSpPr>
        <p:spPr>
          <a:xfrm>
            <a:off x="3977985" y="1378394"/>
            <a:ext cx="2632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-</a:t>
            </a:r>
            <a:endParaRPr lang="fi-FI" sz="2000" b="1" dirty="0"/>
          </a:p>
        </p:txBody>
      </p:sp>
    </p:spTree>
    <p:extLst>
      <p:ext uri="{BB962C8B-B14F-4D97-AF65-F5344CB8AC3E}">
        <p14:creationId xmlns:p14="http://schemas.microsoft.com/office/powerpoint/2010/main" val="375196663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igure5">
            <a:extLst>
              <a:ext uri="{FF2B5EF4-FFF2-40B4-BE49-F238E27FC236}">
                <a16:creationId xmlns:a16="http://schemas.microsoft.com/office/drawing/2014/main" id="{681E8A47-278C-46FF-B0A2-6A74E62AA99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08" t="26158" b="60238"/>
          <a:stretch/>
        </p:blipFill>
        <p:spPr bwMode="auto">
          <a:xfrm>
            <a:off x="3350301" y="1667667"/>
            <a:ext cx="6745575" cy="3522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33E79961-16C5-4523-BC1E-3F836C056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6046" y="95438"/>
            <a:ext cx="10515600" cy="1325563"/>
          </a:xfrm>
        </p:spPr>
        <p:txBody>
          <a:bodyPr/>
          <a:lstStyle/>
          <a:p>
            <a:r>
              <a:rPr lang="fi-FI" dirty="0"/>
              <a:t>Fig. 6c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3986848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D0A83-9C01-46AD-9BA6-3790E983C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4678"/>
            <a:ext cx="10515600" cy="1325563"/>
          </a:xfrm>
        </p:spPr>
        <p:txBody>
          <a:bodyPr/>
          <a:lstStyle/>
          <a:p>
            <a:r>
              <a:rPr lang="fi-FI" dirty="0"/>
              <a:t>P53 and GAPDH</a:t>
            </a:r>
            <a:endParaRPr lang="nb-NO" dirty="0"/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297E588F-FF41-4D4A-B336-64ABD01F49E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656"/>
          <a:stretch/>
        </p:blipFill>
        <p:spPr>
          <a:xfrm flipH="1">
            <a:off x="3753717" y="2670241"/>
            <a:ext cx="4684565" cy="2677439"/>
          </a:xfr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CB1A2A00-0487-4624-B3BD-EF5784B5A159}"/>
              </a:ext>
            </a:extLst>
          </p:cNvPr>
          <p:cNvCxnSpPr/>
          <p:nvPr/>
        </p:nvCxnSpPr>
        <p:spPr>
          <a:xfrm flipH="1">
            <a:off x="7370218" y="3792332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82BF061-5B6F-468F-8841-339204F898FF}"/>
              </a:ext>
            </a:extLst>
          </p:cNvPr>
          <p:cNvSpPr txBox="1"/>
          <p:nvPr/>
        </p:nvSpPr>
        <p:spPr>
          <a:xfrm>
            <a:off x="7732812" y="360766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  <a:endParaRPr lang="fi-FI" dirty="0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E5EE8AE3-6287-43D6-BFAC-E65252427597}"/>
              </a:ext>
            </a:extLst>
          </p:cNvPr>
          <p:cNvCxnSpPr/>
          <p:nvPr/>
        </p:nvCxnSpPr>
        <p:spPr>
          <a:xfrm flipH="1">
            <a:off x="7354162" y="3448112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7FFC8B06-7ADA-41A7-AD05-9A76F0B6719D}"/>
              </a:ext>
            </a:extLst>
          </p:cNvPr>
          <p:cNvSpPr txBox="1"/>
          <p:nvPr/>
        </p:nvSpPr>
        <p:spPr>
          <a:xfrm>
            <a:off x="7716756" y="3263446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53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61250045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42B86-7F1B-4C6C-B4B7-961F4E2B5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5774" y="968008"/>
            <a:ext cx="10515600" cy="1325563"/>
          </a:xfrm>
        </p:spPr>
        <p:txBody>
          <a:bodyPr/>
          <a:lstStyle/>
          <a:p>
            <a:r>
              <a:rPr lang="fi-FI" dirty="0"/>
              <a:t>p53 and GAPDH</a:t>
            </a:r>
            <a:endParaRPr lang="nb-NO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360E88E-E6EB-49EF-9FC6-A762D43637F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404"/>
          <a:stretch/>
        </p:blipFill>
        <p:spPr>
          <a:xfrm flipH="1">
            <a:off x="3003762" y="2293571"/>
            <a:ext cx="6184476" cy="2968239"/>
          </a:xfr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D0EE646-B8BC-42FE-A607-E373EF2D3544}"/>
              </a:ext>
            </a:extLst>
          </p:cNvPr>
          <p:cNvCxnSpPr/>
          <p:nvPr/>
        </p:nvCxnSpPr>
        <p:spPr>
          <a:xfrm flipH="1">
            <a:off x="8033883" y="3728164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DA8E2E1A-921D-424E-A9D4-51A519162191}"/>
              </a:ext>
            </a:extLst>
          </p:cNvPr>
          <p:cNvSpPr txBox="1"/>
          <p:nvPr/>
        </p:nvSpPr>
        <p:spPr>
          <a:xfrm>
            <a:off x="8396477" y="354349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  <a:endParaRPr lang="fi-FI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7A4B357-AD91-4095-9378-048B84183C2B}"/>
              </a:ext>
            </a:extLst>
          </p:cNvPr>
          <p:cNvCxnSpPr/>
          <p:nvPr/>
        </p:nvCxnSpPr>
        <p:spPr>
          <a:xfrm flipH="1">
            <a:off x="8033883" y="3327796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CE9B0FE-58AB-4A5E-A1B0-9B9E5481E127}"/>
              </a:ext>
            </a:extLst>
          </p:cNvPr>
          <p:cNvSpPr txBox="1"/>
          <p:nvPr/>
        </p:nvSpPr>
        <p:spPr>
          <a:xfrm>
            <a:off x="8396477" y="3143130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53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729544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Research\Denis Paper_10052020\Western Blot_21052020\Denis_p53 2020-05-19 12h06m39s(Composite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7213" y="1006131"/>
            <a:ext cx="5214424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AE3A95D-E758-44A7-B8DE-8ADCAAF0FF1D}"/>
              </a:ext>
            </a:extLst>
          </p:cNvPr>
          <p:cNvSpPr txBox="1"/>
          <p:nvPr/>
        </p:nvSpPr>
        <p:spPr>
          <a:xfrm>
            <a:off x="3278509" y="114724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9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C976C24-597F-4FB4-9C53-4B16E5C3D17F}"/>
              </a:ext>
            </a:extLst>
          </p:cNvPr>
          <p:cNvSpPr txBox="1"/>
          <p:nvPr/>
        </p:nvSpPr>
        <p:spPr>
          <a:xfrm>
            <a:off x="3278509" y="183196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6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221878-6D41-4701-A09A-91812C4814D0}"/>
              </a:ext>
            </a:extLst>
          </p:cNvPr>
          <p:cNvSpPr txBox="1"/>
          <p:nvPr/>
        </p:nvSpPr>
        <p:spPr>
          <a:xfrm>
            <a:off x="3278509" y="251808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4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694F33-D349-4AFC-9B63-A1B1BFBD23A7}"/>
              </a:ext>
            </a:extLst>
          </p:cNvPr>
          <p:cNvSpPr txBox="1"/>
          <p:nvPr/>
        </p:nvSpPr>
        <p:spPr>
          <a:xfrm>
            <a:off x="3278509" y="31870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3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1F4E70-A4AE-4807-8B50-5F20F165564E}"/>
              </a:ext>
            </a:extLst>
          </p:cNvPr>
          <p:cNvSpPr txBox="1"/>
          <p:nvPr/>
        </p:nvSpPr>
        <p:spPr>
          <a:xfrm>
            <a:off x="3278509" y="379427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2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F989BD-2D8A-4AFB-824B-CCF99A276155}"/>
              </a:ext>
            </a:extLst>
          </p:cNvPr>
          <p:cNvSpPr txBox="1"/>
          <p:nvPr/>
        </p:nvSpPr>
        <p:spPr>
          <a:xfrm>
            <a:off x="3278509" y="438296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17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3886043" y="4747642"/>
            <a:ext cx="5024919" cy="807967"/>
            <a:chOff x="3886043" y="4747642"/>
            <a:chExt cx="5024919" cy="807967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1ABF4C5-F1BE-481C-A070-C0CDD06C41C0}"/>
                </a:ext>
              </a:extLst>
            </p:cNvPr>
            <p:cNvSpPr txBox="1"/>
            <p:nvPr/>
          </p:nvSpPr>
          <p:spPr>
            <a:xfrm>
              <a:off x="4073718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629B69F-4FB7-4194-82DC-1534DEE803BB}"/>
                </a:ext>
              </a:extLst>
            </p:cNvPr>
            <p:cNvSpPr txBox="1"/>
            <p:nvPr/>
          </p:nvSpPr>
          <p:spPr>
            <a:xfrm>
              <a:off x="4421816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3C051C3-FAB1-4C5D-9665-AE9B8BD2C82B}"/>
                </a:ext>
              </a:extLst>
            </p:cNvPr>
            <p:cNvSpPr txBox="1"/>
            <p:nvPr/>
          </p:nvSpPr>
          <p:spPr>
            <a:xfrm>
              <a:off x="490077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0A2CC7F-9BBD-48C6-A77E-DCD58039A810}"/>
                </a:ext>
              </a:extLst>
            </p:cNvPr>
            <p:cNvSpPr txBox="1"/>
            <p:nvPr/>
          </p:nvSpPr>
          <p:spPr>
            <a:xfrm>
              <a:off x="524080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93062E5-2267-4FDE-9926-600AF3445427}"/>
                </a:ext>
              </a:extLst>
            </p:cNvPr>
            <p:cNvSpPr txBox="1"/>
            <p:nvPr/>
          </p:nvSpPr>
          <p:spPr>
            <a:xfrm>
              <a:off x="5611590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9EF9D8F-10D8-4C76-A5D9-F4F9338621A2}"/>
                </a:ext>
              </a:extLst>
            </p:cNvPr>
            <p:cNvSpPr txBox="1"/>
            <p:nvPr/>
          </p:nvSpPr>
          <p:spPr>
            <a:xfrm>
              <a:off x="598532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A9A3FDB-A500-4BEF-AB90-A58856393C0B}"/>
                </a:ext>
              </a:extLst>
            </p:cNvPr>
            <p:cNvSpPr txBox="1"/>
            <p:nvPr/>
          </p:nvSpPr>
          <p:spPr>
            <a:xfrm>
              <a:off x="6413009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6F652A4-5749-4585-A212-E2E04AD50B01}"/>
                </a:ext>
              </a:extLst>
            </p:cNvPr>
            <p:cNvSpPr txBox="1"/>
            <p:nvPr/>
          </p:nvSpPr>
          <p:spPr>
            <a:xfrm>
              <a:off x="6735947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1888E71-DFBF-4B7F-B90A-DDCE5202D944}"/>
                </a:ext>
              </a:extLst>
            </p:cNvPr>
            <p:cNvSpPr txBox="1"/>
            <p:nvPr/>
          </p:nvSpPr>
          <p:spPr>
            <a:xfrm>
              <a:off x="711644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495E67F-9108-4E65-A76C-EA372B5F9EB8}"/>
                </a:ext>
              </a:extLst>
            </p:cNvPr>
            <p:cNvSpPr txBox="1"/>
            <p:nvPr/>
          </p:nvSpPr>
          <p:spPr>
            <a:xfrm>
              <a:off x="750727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AE16A4E-59A6-4CD3-B13D-B10D80244ED0}"/>
                </a:ext>
              </a:extLst>
            </p:cNvPr>
            <p:cNvSpPr txBox="1"/>
            <p:nvPr/>
          </p:nvSpPr>
          <p:spPr>
            <a:xfrm>
              <a:off x="794350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E5B253A-BFF5-4308-8081-E995D9D79B34}"/>
                </a:ext>
              </a:extLst>
            </p:cNvPr>
            <p:cNvSpPr txBox="1"/>
            <p:nvPr/>
          </p:nvSpPr>
          <p:spPr>
            <a:xfrm>
              <a:off x="8343354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E24EF46-0088-4D5A-AD2E-FF4700A2E1E1}"/>
                </a:ext>
              </a:extLst>
            </p:cNvPr>
            <p:cNvCxnSpPr/>
            <p:nvPr/>
          </p:nvCxnSpPr>
          <p:spPr>
            <a:xfrm>
              <a:off x="3886043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21AC3800-183F-4A90-9ACA-2BEDCF8C4B76}"/>
                </a:ext>
              </a:extLst>
            </p:cNvPr>
            <p:cNvCxnSpPr/>
            <p:nvPr/>
          </p:nvCxnSpPr>
          <p:spPr>
            <a:xfrm>
              <a:off x="5558008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61AF061F-47B0-44E7-AD8E-B2CD5E00913D}"/>
                </a:ext>
              </a:extLst>
            </p:cNvPr>
            <p:cNvCxnSpPr/>
            <p:nvPr/>
          </p:nvCxnSpPr>
          <p:spPr>
            <a:xfrm>
              <a:off x="7261992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86B81AF-1509-4DFE-8425-9F0F5C95CF02}"/>
                </a:ext>
              </a:extLst>
            </p:cNvPr>
            <p:cNvSpPr txBox="1"/>
            <p:nvPr/>
          </p:nvSpPr>
          <p:spPr>
            <a:xfrm>
              <a:off x="4308985" y="5186277"/>
              <a:ext cx="10081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Whol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3D27923-47D9-4B5D-92A6-F497F13639EB}"/>
                </a:ext>
              </a:extLst>
            </p:cNvPr>
            <p:cNvSpPr txBox="1"/>
            <p:nvPr/>
          </p:nvSpPr>
          <p:spPr>
            <a:xfrm>
              <a:off x="5908333" y="5186277"/>
              <a:ext cx="874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Cytosol</a:t>
              </a:r>
              <a:endParaRPr lang="nb-NO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D8B02B0-63D4-44CC-BF57-12B71DC4C9AD}"/>
                </a:ext>
              </a:extLst>
            </p:cNvPr>
            <p:cNvSpPr txBox="1"/>
            <p:nvPr/>
          </p:nvSpPr>
          <p:spPr>
            <a:xfrm>
              <a:off x="7495776" y="5186277"/>
              <a:ext cx="1173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Nucleus</a:t>
              </a:r>
              <a:endParaRPr lang="nb-NO" dirty="0"/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C3A74227-E2CF-40DB-A9F2-6F1F9892EDFF}"/>
              </a:ext>
            </a:extLst>
          </p:cNvPr>
          <p:cNvSpPr txBox="1"/>
          <p:nvPr/>
        </p:nvSpPr>
        <p:spPr>
          <a:xfrm>
            <a:off x="8911637" y="2621465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p53</a:t>
            </a:r>
          </a:p>
        </p:txBody>
      </p:sp>
    </p:spTree>
    <p:extLst>
      <p:ext uri="{BB962C8B-B14F-4D97-AF65-F5344CB8AC3E}">
        <p14:creationId xmlns:p14="http://schemas.microsoft.com/office/powerpoint/2010/main" val="35733207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Research\Denis Paper_10052020\Western Blot_21052020\Denis_Bcl-xL Com 2020-05-19 12h13m33s(Composite)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6117" y="902746"/>
            <a:ext cx="5134719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AE3A95D-E758-44A7-B8DE-8ADCAAF0FF1D}"/>
              </a:ext>
            </a:extLst>
          </p:cNvPr>
          <p:cNvSpPr txBox="1"/>
          <p:nvPr/>
        </p:nvSpPr>
        <p:spPr>
          <a:xfrm>
            <a:off x="3227233" y="114724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9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C976C24-597F-4FB4-9C53-4B16E5C3D17F}"/>
              </a:ext>
            </a:extLst>
          </p:cNvPr>
          <p:cNvSpPr txBox="1"/>
          <p:nvPr/>
        </p:nvSpPr>
        <p:spPr>
          <a:xfrm>
            <a:off x="3227233" y="183196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6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221878-6D41-4701-A09A-91812C4814D0}"/>
              </a:ext>
            </a:extLst>
          </p:cNvPr>
          <p:cNvSpPr txBox="1"/>
          <p:nvPr/>
        </p:nvSpPr>
        <p:spPr>
          <a:xfrm>
            <a:off x="3227233" y="251808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4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694F33-D349-4AFC-9B63-A1B1BFBD23A7}"/>
              </a:ext>
            </a:extLst>
          </p:cNvPr>
          <p:cNvSpPr txBox="1"/>
          <p:nvPr/>
        </p:nvSpPr>
        <p:spPr>
          <a:xfrm>
            <a:off x="3227233" y="31870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3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1F4E70-A4AE-4807-8B50-5F20F165564E}"/>
              </a:ext>
            </a:extLst>
          </p:cNvPr>
          <p:cNvSpPr txBox="1"/>
          <p:nvPr/>
        </p:nvSpPr>
        <p:spPr>
          <a:xfrm>
            <a:off x="3227233" y="379427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28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3847614" y="4562976"/>
            <a:ext cx="5024919" cy="807967"/>
            <a:chOff x="3886043" y="4747642"/>
            <a:chExt cx="5024919" cy="807967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1ABF4C5-F1BE-481C-A070-C0CDD06C41C0}"/>
                </a:ext>
              </a:extLst>
            </p:cNvPr>
            <p:cNvSpPr txBox="1"/>
            <p:nvPr/>
          </p:nvSpPr>
          <p:spPr>
            <a:xfrm>
              <a:off x="4073718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629B69F-4FB7-4194-82DC-1534DEE803BB}"/>
                </a:ext>
              </a:extLst>
            </p:cNvPr>
            <p:cNvSpPr txBox="1"/>
            <p:nvPr/>
          </p:nvSpPr>
          <p:spPr>
            <a:xfrm>
              <a:off x="447309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3C051C3-FAB1-4C5D-9665-AE9B8BD2C82B}"/>
                </a:ext>
              </a:extLst>
            </p:cNvPr>
            <p:cNvSpPr txBox="1"/>
            <p:nvPr/>
          </p:nvSpPr>
          <p:spPr>
            <a:xfrm>
              <a:off x="490077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0A2CC7F-9BBD-48C6-A77E-DCD58039A810}"/>
                </a:ext>
              </a:extLst>
            </p:cNvPr>
            <p:cNvSpPr txBox="1"/>
            <p:nvPr/>
          </p:nvSpPr>
          <p:spPr>
            <a:xfrm>
              <a:off x="524080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93062E5-2267-4FDE-9926-600AF3445427}"/>
                </a:ext>
              </a:extLst>
            </p:cNvPr>
            <p:cNvSpPr txBox="1"/>
            <p:nvPr/>
          </p:nvSpPr>
          <p:spPr>
            <a:xfrm>
              <a:off x="5611590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9EF9D8F-10D8-4C76-A5D9-F4F9338621A2}"/>
                </a:ext>
              </a:extLst>
            </p:cNvPr>
            <p:cNvSpPr txBox="1"/>
            <p:nvPr/>
          </p:nvSpPr>
          <p:spPr>
            <a:xfrm>
              <a:off x="598532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A9A3FDB-A500-4BEF-AB90-A58856393C0B}"/>
                </a:ext>
              </a:extLst>
            </p:cNvPr>
            <p:cNvSpPr txBox="1"/>
            <p:nvPr/>
          </p:nvSpPr>
          <p:spPr>
            <a:xfrm>
              <a:off x="633609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6F652A4-5749-4585-A212-E2E04AD50B01}"/>
                </a:ext>
              </a:extLst>
            </p:cNvPr>
            <p:cNvSpPr txBox="1"/>
            <p:nvPr/>
          </p:nvSpPr>
          <p:spPr>
            <a:xfrm>
              <a:off x="6693217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1888E71-DFBF-4B7F-B90A-DDCE5202D944}"/>
                </a:ext>
              </a:extLst>
            </p:cNvPr>
            <p:cNvSpPr txBox="1"/>
            <p:nvPr/>
          </p:nvSpPr>
          <p:spPr>
            <a:xfrm>
              <a:off x="711644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495E67F-9108-4E65-A76C-EA372B5F9EB8}"/>
                </a:ext>
              </a:extLst>
            </p:cNvPr>
            <p:cNvSpPr txBox="1"/>
            <p:nvPr/>
          </p:nvSpPr>
          <p:spPr>
            <a:xfrm>
              <a:off x="750727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AE16A4E-59A6-4CD3-B13D-B10D80244ED0}"/>
                </a:ext>
              </a:extLst>
            </p:cNvPr>
            <p:cNvSpPr txBox="1"/>
            <p:nvPr/>
          </p:nvSpPr>
          <p:spPr>
            <a:xfrm>
              <a:off x="7832404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E5B253A-BFF5-4308-8081-E995D9D79B34}"/>
                </a:ext>
              </a:extLst>
            </p:cNvPr>
            <p:cNvSpPr txBox="1"/>
            <p:nvPr/>
          </p:nvSpPr>
          <p:spPr>
            <a:xfrm>
              <a:off x="8232256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E24EF46-0088-4D5A-AD2E-FF4700A2E1E1}"/>
                </a:ext>
              </a:extLst>
            </p:cNvPr>
            <p:cNvCxnSpPr/>
            <p:nvPr/>
          </p:nvCxnSpPr>
          <p:spPr>
            <a:xfrm>
              <a:off x="3886043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21AC3800-183F-4A90-9ACA-2BEDCF8C4B76}"/>
                </a:ext>
              </a:extLst>
            </p:cNvPr>
            <p:cNvCxnSpPr/>
            <p:nvPr/>
          </p:nvCxnSpPr>
          <p:spPr>
            <a:xfrm>
              <a:off x="5558008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61AF061F-47B0-44E7-AD8E-B2CD5E00913D}"/>
                </a:ext>
              </a:extLst>
            </p:cNvPr>
            <p:cNvCxnSpPr/>
            <p:nvPr/>
          </p:nvCxnSpPr>
          <p:spPr>
            <a:xfrm>
              <a:off x="7261992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86B81AF-1509-4DFE-8425-9F0F5C95CF02}"/>
                </a:ext>
              </a:extLst>
            </p:cNvPr>
            <p:cNvSpPr txBox="1"/>
            <p:nvPr/>
          </p:nvSpPr>
          <p:spPr>
            <a:xfrm>
              <a:off x="4308985" y="5186277"/>
              <a:ext cx="10081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Whol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3D27923-47D9-4B5D-92A6-F497F13639EB}"/>
                </a:ext>
              </a:extLst>
            </p:cNvPr>
            <p:cNvSpPr txBox="1"/>
            <p:nvPr/>
          </p:nvSpPr>
          <p:spPr>
            <a:xfrm>
              <a:off x="5908333" y="5186277"/>
              <a:ext cx="874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Cytosol</a:t>
              </a:r>
              <a:endParaRPr lang="nb-NO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D8B02B0-63D4-44CC-BF57-12B71DC4C9AD}"/>
                </a:ext>
              </a:extLst>
            </p:cNvPr>
            <p:cNvSpPr txBox="1"/>
            <p:nvPr/>
          </p:nvSpPr>
          <p:spPr>
            <a:xfrm>
              <a:off x="7495776" y="5186277"/>
              <a:ext cx="1173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Nucleus</a:t>
              </a:r>
              <a:endParaRPr lang="nb-NO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720836" y="369124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Bcl-x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9360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6784" y="1144317"/>
            <a:ext cx="4975592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E3A95D-E758-44A7-B8DE-8ADCAAF0FF1D}"/>
              </a:ext>
            </a:extLst>
          </p:cNvPr>
          <p:cNvSpPr txBox="1"/>
          <p:nvPr/>
        </p:nvSpPr>
        <p:spPr>
          <a:xfrm>
            <a:off x="3227233" y="123270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98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C976C24-597F-4FB4-9C53-4B16E5C3D17F}"/>
              </a:ext>
            </a:extLst>
          </p:cNvPr>
          <p:cNvSpPr txBox="1"/>
          <p:nvPr/>
        </p:nvSpPr>
        <p:spPr>
          <a:xfrm>
            <a:off x="3227233" y="185760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6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221878-6D41-4701-A09A-91812C4814D0}"/>
              </a:ext>
            </a:extLst>
          </p:cNvPr>
          <p:cNvSpPr txBox="1"/>
          <p:nvPr/>
        </p:nvSpPr>
        <p:spPr>
          <a:xfrm>
            <a:off x="3227233" y="239843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4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E694F33-D349-4AFC-9B63-A1B1BFBD23A7}"/>
              </a:ext>
            </a:extLst>
          </p:cNvPr>
          <p:cNvSpPr txBox="1"/>
          <p:nvPr/>
        </p:nvSpPr>
        <p:spPr>
          <a:xfrm>
            <a:off x="3227233" y="306739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3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1F4E70-A4AE-4807-8B50-5F20F165564E}"/>
              </a:ext>
            </a:extLst>
          </p:cNvPr>
          <p:cNvSpPr txBox="1"/>
          <p:nvPr/>
        </p:nvSpPr>
        <p:spPr>
          <a:xfrm>
            <a:off x="3227233" y="367463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2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1F4E70-A4AE-4807-8B50-5F20F165564E}"/>
              </a:ext>
            </a:extLst>
          </p:cNvPr>
          <p:cNvSpPr txBox="1"/>
          <p:nvPr/>
        </p:nvSpPr>
        <p:spPr>
          <a:xfrm>
            <a:off x="3238080" y="432370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17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3785206" y="4778480"/>
            <a:ext cx="5179332" cy="807967"/>
            <a:chOff x="3886043" y="4747642"/>
            <a:chExt cx="5024919" cy="807967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1ABF4C5-F1BE-481C-A070-C0CDD06C41C0}"/>
                </a:ext>
              </a:extLst>
            </p:cNvPr>
            <p:cNvSpPr txBox="1"/>
            <p:nvPr/>
          </p:nvSpPr>
          <p:spPr>
            <a:xfrm>
              <a:off x="4073718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629B69F-4FB7-4194-82DC-1534DEE803BB}"/>
                </a:ext>
              </a:extLst>
            </p:cNvPr>
            <p:cNvSpPr txBox="1"/>
            <p:nvPr/>
          </p:nvSpPr>
          <p:spPr>
            <a:xfrm>
              <a:off x="447309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3C051C3-FAB1-4C5D-9665-AE9B8BD2C82B}"/>
                </a:ext>
              </a:extLst>
            </p:cNvPr>
            <p:cNvSpPr txBox="1"/>
            <p:nvPr/>
          </p:nvSpPr>
          <p:spPr>
            <a:xfrm>
              <a:off x="490077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0A2CC7F-9BBD-48C6-A77E-DCD58039A810}"/>
                </a:ext>
              </a:extLst>
            </p:cNvPr>
            <p:cNvSpPr txBox="1"/>
            <p:nvPr/>
          </p:nvSpPr>
          <p:spPr>
            <a:xfrm>
              <a:off x="524080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93062E5-2267-4FDE-9926-600AF3445427}"/>
                </a:ext>
              </a:extLst>
            </p:cNvPr>
            <p:cNvSpPr txBox="1"/>
            <p:nvPr/>
          </p:nvSpPr>
          <p:spPr>
            <a:xfrm>
              <a:off x="5611590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9EF9D8F-10D8-4C76-A5D9-F4F9338621A2}"/>
                </a:ext>
              </a:extLst>
            </p:cNvPr>
            <p:cNvSpPr txBox="1"/>
            <p:nvPr/>
          </p:nvSpPr>
          <p:spPr>
            <a:xfrm>
              <a:off x="598532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A9A3FDB-A500-4BEF-AB90-A58856393C0B}"/>
                </a:ext>
              </a:extLst>
            </p:cNvPr>
            <p:cNvSpPr txBox="1"/>
            <p:nvPr/>
          </p:nvSpPr>
          <p:spPr>
            <a:xfrm>
              <a:off x="633609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6F652A4-5749-4585-A212-E2E04AD50B01}"/>
                </a:ext>
              </a:extLst>
            </p:cNvPr>
            <p:cNvSpPr txBox="1"/>
            <p:nvPr/>
          </p:nvSpPr>
          <p:spPr>
            <a:xfrm>
              <a:off x="6693217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1888E71-DFBF-4B7F-B90A-DDCE5202D944}"/>
                </a:ext>
              </a:extLst>
            </p:cNvPr>
            <p:cNvSpPr txBox="1"/>
            <p:nvPr/>
          </p:nvSpPr>
          <p:spPr>
            <a:xfrm>
              <a:off x="7116445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495E67F-9108-4E65-A76C-EA372B5F9EB8}"/>
                </a:ext>
              </a:extLst>
            </p:cNvPr>
            <p:cNvSpPr txBox="1"/>
            <p:nvPr/>
          </p:nvSpPr>
          <p:spPr>
            <a:xfrm>
              <a:off x="7507272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AE16A4E-59A6-4CD3-B13D-B10D80244ED0}"/>
                </a:ext>
              </a:extLst>
            </p:cNvPr>
            <p:cNvSpPr txBox="1"/>
            <p:nvPr/>
          </p:nvSpPr>
          <p:spPr>
            <a:xfrm>
              <a:off x="7832404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E5B253A-BFF5-4308-8081-E995D9D79B34}"/>
                </a:ext>
              </a:extLst>
            </p:cNvPr>
            <p:cNvSpPr txBox="1"/>
            <p:nvPr/>
          </p:nvSpPr>
          <p:spPr>
            <a:xfrm>
              <a:off x="8232256" y="4747642"/>
              <a:ext cx="379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2E24EF46-0088-4D5A-AD2E-FF4700A2E1E1}"/>
                </a:ext>
              </a:extLst>
            </p:cNvPr>
            <p:cNvCxnSpPr/>
            <p:nvPr/>
          </p:nvCxnSpPr>
          <p:spPr>
            <a:xfrm>
              <a:off x="3886043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21AC3800-183F-4A90-9ACA-2BEDCF8C4B76}"/>
                </a:ext>
              </a:extLst>
            </p:cNvPr>
            <p:cNvCxnSpPr/>
            <p:nvPr/>
          </p:nvCxnSpPr>
          <p:spPr>
            <a:xfrm>
              <a:off x="5558008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61AF061F-47B0-44E7-AD8E-B2CD5E00913D}"/>
                </a:ext>
              </a:extLst>
            </p:cNvPr>
            <p:cNvCxnSpPr/>
            <p:nvPr/>
          </p:nvCxnSpPr>
          <p:spPr>
            <a:xfrm>
              <a:off x="7261992" y="5159711"/>
              <a:ext cx="164897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86B81AF-1509-4DFE-8425-9F0F5C95CF02}"/>
                </a:ext>
              </a:extLst>
            </p:cNvPr>
            <p:cNvSpPr txBox="1"/>
            <p:nvPr/>
          </p:nvSpPr>
          <p:spPr>
            <a:xfrm>
              <a:off x="4308985" y="5186277"/>
              <a:ext cx="10081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Whol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3D27923-47D9-4B5D-92A6-F497F13639EB}"/>
                </a:ext>
              </a:extLst>
            </p:cNvPr>
            <p:cNvSpPr txBox="1"/>
            <p:nvPr/>
          </p:nvSpPr>
          <p:spPr>
            <a:xfrm>
              <a:off x="5908333" y="5186277"/>
              <a:ext cx="874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Cytosol</a:t>
              </a:r>
              <a:endParaRPr lang="nb-NO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D8B02B0-63D4-44CC-BF57-12B71DC4C9AD}"/>
                </a:ext>
              </a:extLst>
            </p:cNvPr>
            <p:cNvSpPr txBox="1"/>
            <p:nvPr/>
          </p:nvSpPr>
          <p:spPr>
            <a:xfrm>
              <a:off x="7495776" y="5186277"/>
              <a:ext cx="1173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Nucleus</a:t>
              </a:r>
              <a:endParaRPr lang="nb-NO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632376" y="314616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GAPD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24405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9776" y="1412776"/>
            <a:ext cx="3898454" cy="32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591944" y="849559"/>
            <a:ext cx="659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PAXX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A285C85-1D3D-438E-80A4-A285CDA2CC81}"/>
              </a:ext>
            </a:extLst>
          </p:cNvPr>
          <p:cNvSpPr txBox="1"/>
          <p:nvPr/>
        </p:nvSpPr>
        <p:spPr>
          <a:xfrm>
            <a:off x="8378158" y="3089976"/>
            <a:ext cx="659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P</a:t>
            </a:r>
            <a:r>
              <a:rPr lang="nb-NO" dirty="0"/>
              <a:t>AXX</a:t>
            </a:r>
            <a:endParaRPr lang="en-US" dirty="0"/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B199890-993D-44EE-A1C3-130B6497E73C}"/>
              </a:ext>
            </a:extLst>
          </p:cNvPr>
          <p:cNvCxnSpPr/>
          <p:nvPr/>
        </p:nvCxnSpPr>
        <p:spPr>
          <a:xfrm flipH="1">
            <a:off x="8053233" y="3279302"/>
            <a:ext cx="372905" cy="0"/>
          </a:xfrm>
          <a:prstGeom prst="straightConnector1">
            <a:avLst/>
          </a:prstGeom>
          <a:ln w="222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0E3EDF94-7016-46FF-AAEA-EA457B63C6F3}"/>
              </a:ext>
            </a:extLst>
          </p:cNvPr>
          <p:cNvSpPr txBox="1"/>
          <p:nvPr/>
        </p:nvSpPr>
        <p:spPr>
          <a:xfrm>
            <a:off x="3644750" y="133586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9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7DD55A-004F-468B-965C-0FB4704EC2B1}"/>
              </a:ext>
            </a:extLst>
          </p:cNvPr>
          <p:cNvSpPr txBox="1"/>
          <p:nvPr/>
        </p:nvSpPr>
        <p:spPr>
          <a:xfrm>
            <a:off x="3644750" y="196076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6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5F2FB7-CA06-4837-9A34-0D8FA43723D3}"/>
              </a:ext>
            </a:extLst>
          </p:cNvPr>
          <p:cNvSpPr txBox="1"/>
          <p:nvPr/>
        </p:nvSpPr>
        <p:spPr>
          <a:xfrm>
            <a:off x="3644750" y="250159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4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1BA566-E28F-4355-8F9D-6C98F334477E}"/>
              </a:ext>
            </a:extLst>
          </p:cNvPr>
          <p:cNvSpPr txBox="1"/>
          <p:nvPr/>
        </p:nvSpPr>
        <p:spPr>
          <a:xfrm>
            <a:off x="3644750" y="299067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3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997C71-60E5-4424-9205-BAEDAFF0C22A}"/>
              </a:ext>
            </a:extLst>
          </p:cNvPr>
          <p:cNvSpPr txBox="1"/>
          <p:nvPr/>
        </p:nvSpPr>
        <p:spPr>
          <a:xfrm>
            <a:off x="3644750" y="337306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2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64ECB92-7EED-40BA-9342-317CC5C17826}"/>
              </a:ext>
            </a:extLst>
          </p:cNvPr>
          <p:cNvSpPr txBox="1"/>
          <p:nvPr/>
        </p:nvSpPr>
        <p:spPr>
          <a:xfrm>
            <a:off x="3655597" y="402213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17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EB27137-6CB4-44EF-AD0F-0C836066B6D5}"/>
              </a:ext>
            </a:extLst>
          </p:cNvPr>
          <p:cNvGrpSpPr/>
          <p:nvPr/>
        </p:nvGrpSpPr>
        <p:grpSpPr>
          <a:xfrm>
            <a:off x="4262743" y="4687695"/>
            <a:ext cx="3715488" cy="757529"/>
            <a:chOff x="3323293" y="5018756"/>
            <a:chExt cx="3996377" cy="765230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3AABDA3-C938-463A-8180-8B6EE93D3223}"/>
                </a:ext>
              </a:extLst>
            </p:cNvPr>
            <p:cNvSpPr txBox="1"/>
            <p:nvPr/>
          </p:nvSpPr>
          <p:spPr>
            <a:xfrm>
              <a:off x="334158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E46B8C9-BB05-47A8-B3F4-C5A07A3B0F2C}"/>
                </a:ext>
              </a:extLst>
            </p:cNvPr>
            <p:cNvSpPr txBox="1"/>
            <p:nvPr/>
          </p:nvSpPr>
          <p:spPr>
            <a:xfrm>
              <a:off x="365241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5276AC3-D20B-448A-831A-4396041BB66D}"/>
                </a:ext>
              </a:extLst>
            </p:cNvPr>
            <p:cNvSpPr txBox="1"/>
            <p:nvPr/>
          </p:nvSpPr>
          <p:spPr>
            <a:xfrm>
              <a:off x="400614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D54431F-38CA-43DC-A461-EB0A63D7721C}"/>
                </a:ext>
              </a:extLst>
            </p:cNvPr>
            <p:cNvSpPr txBox="1"/>
            <p:nvPr/>
          </p:nvSpPr>
          <p:spPr>
            <a:xfrm>
              <a:off x="4351340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216B7FC-A60F-446A-B156-3F33C6C6B89A}"/>
                </a:ext>
              </a:extLst>
            </p:cNvPr>
            <p:cNvSpPr txBox="1"/>
            <p:nvPr/>
          </p:nvSpPr>
          <p:spPr>
            <a:xfrm>
              <a:off x="465302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EBF1513-A258-41A2-A68E-EED37FE931C1}"/>
                </a:ext>
              </a:extLst>
            </p:cNvPr>
            <p:cNvSpPr txBox="1"/>
            <p:nvPr/>
          </p:nvSpPr>
          <p:spPr>
            <a:xfrm>
              <a:off x="496385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6C188EE-9B60-4A34-827A-BFDD83327D05}"/>
                </a:ext>
              </a:extLst>
            </p:cNvPr>
            <p:cNvSpPr txBox="1"/>
            <p:nvPr/>
          </p:nvSpPr>
          <p:spPr>
            <a:xfrm>
              <a:off x="531759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017607-9DCE-487C-B211-1A563E1D849A}"/>
                </a:ext>
              </a:extLst>
            </p:cNvPr>
            <p:cNvSpPr txBox="1"/>
            <p:nvPr/>
          </p:nvSpPr>
          <p:spPr>
            <a:xfrm>
              <a:off x="5662785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9EC8EE0-2FB2-43BD-901A-CB56091ED433}"/>
                </a:ext>
              </a:extLst>
            </p:cNvPr>
            <p:cNvSpPr txBox="1"/>
            <p:nvPr/>
          </p:nvSpPr>
          <p:spPr>
            <a:xfrm>
              <a:off x="5999383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AD51E9C-A5AF-49FD-A56A-C27CEEB08F8F}"/>
                </a:ext>
              </a:extLst>
            </p:cNvPr>
            <p:cNvSpPr txBox="1"/>
            <p:nvPr/>
          </p:nvSpPr>
          <p:spPr>
            <a:xfrm>
              <a:off x="6310213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D224207-1B60-4D99-897D-C9A2B60C0347}"/>
                </a:ext>
              </a:extLst>
            </p:cNvPr>
            <p:cNvSpPr txBox="1"/>
            <p:nvPr/>
          </p:nvSpPr>
          <p:spPr>
            <a:xfrm>
              <a:off x="6663948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83A2B9E-7D3B-452B-AE6F-1BE94F43D97D}"/>
                </a:ext>
              </a:extLst>
            </p:cNvPr>
            <p:cNvSpPr txBox="1"/>
            <p:nvPr/>
          </p:nvSpPr>
          <p:spPr>
            <a:xfrm>
              <a:off x="7009142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49DB5B5E-2270-4CE5-98D6-9829B639CBEF}"/>
                </a:ext>
              </a:extLst>
            </p:cNvPr>
            <p:cNvCxnSpPr/>
            <p:nvPr/>
          </p:nvCxnSpPr>
          <p:spPr>
            <a:xfrm>
              <a:off x="3323293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6540C24C-EBD1-4C02-835F-B5601A086DEA}"/>
                </a:ext>
              </a:extLst>
            </p:cNvPr>
            <p:cNvCxnSpPr/>
            <p:nvPr/>
          </p:nvCxnSpPr>
          <p:spPr>
            <a:xfrm>
              <a:off x="4653026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A2B22108-5BE0-42F0-8DE3-A61FC3DE3677}"/>
                </a:ext>
              </a:extLst>
            </p:cNvPr>
            <p:cNvCxnSpPr/>
            <p:nvPr/>
          </p:nvCxnSpPr>
          <p:spPr>
            <a:xfrm>
              <a:off x="6008225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FD0E87C-9562-4A7E-BD63-E15D30D82E8E}"/>
                </a:ext>
              </a:extLst>
            </p:cNvPr>
            <p:cNvSpPr txBox="1"/>
            <p:nvPr/>
          </p:nvSpPr>
          <p:spPr>
            <a:xfrm>
              <a:off x="3578103" y="5414654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Whol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4975980-44E6-4E2A-8542-DDAF2446824B}"/>
                </a:ext>
              </a:extLst>
            </p:cNvPr>
            <p:cNvSpPr txBox="1"/>
            <p:nvPr/>
          </p:nvSpPr>
          <p:spPr>
            <a:xfrm>
              <a:off x="4741335" y="5414654"/>
              <a:ext cx="874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Cytosol</a:t>
              </a:r>
              <a:endParaRPr lang="nb-NO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C15A4F7-D0FA-448A-97BE-AAFED9B9B0DC}"/>
                </a:ext>
              </a:extLst>
            </p:cNvPr>
            <p:cNvSpPr txBox="1"/>
            <p:nvPr/>
          </p:nvSpPr>
          <p:spPr>
            <a:xfrm>
              <a:off x="6194156" y="5414654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Nucleus</a:t>
              </a:r>
              <a:endParaRPr lang="nb-NO" dirty="0"/>
            </a:p>
          </p:txBody>
        </p:sp>
      </p:grpSp>
    </p:spTree>
    <p:extLst>
      <p:ext uri="{BB962C8B-B14F-4D97-AF65-F5344CB8AC3E}">
        <p14:creationId xmlns:p14="http://schemas.microsoft.com/office/powerpoint/2010/main" val="8582445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5761" y="1412776"/>
            <a:ext cx="4223989" cy="32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>
            <a:off x="3645151" y="4117722"/>
            <a:ext cx="524166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202158" y="3923764"/>
            <a:ext cx="517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Bax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735960" y="918012"/>
            <a:ext cx="517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Bax</a:t>
            </a:r>
            <a:endParaRPr lang="en-US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72F46FD-FEB4-42FF-8587-BF34DD621506}"/>
              </a:ext>
            </a:extLst>
          </p:cNvPr>
          <p:cNvGrpSpPr/>
          <p:nvPr/>
        </p:nvGrpSpPr>
        <p:grpSpPr>
          <a:xfrm>
            <a:off x="4262742" y="4687695"/>
            <a:ext cx="3996377" cy="765230"/>
            <a:chOff x="3323293" y="5018756"/>
            <a:chExt cx="3996377" cy="76523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ABF4C5-F1BE-481C-A070-C0CDD06C41C0}"/>
                </a:ext>
              </a:extLst>
            </p:cNvPr>
            <p:cNvSpPr txBox="1"/>
            <p:nvPr/>
          </p:nvSpPr>
          <p:spPr>
            <a:xfrm>
              <a:off x="334158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29B69F-4FB7-4194-82DC-1534DEE803BB}"/>
                </a:ext>
              </a:extLst>
            </p:cNvPr>
            <p:cNvSpPr txBox="1"/>
            <p:nvPr/>
          </p:nvSpPr>
          <p:spPr>
            <a:xfrm>
              <a:off x="365241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3C051C3-FAB1-4C5D-9665-AE9B8BD2C82B}"/>
                </a:ext>
              </a:extLst>
            </p:cNvPr>
            <p:cNvSpPr txBox="1"/>
            <p:nvPr/>
          </p:nvSpPr>
          <p:spPr>
            <a:xfrm>
              <a:off x="400614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0A2CC7F-9BBD-48C6-A77E-DCD58039A810}"/>
                </a:ext>
              </a:extLst>
            </p:cNvPr>
            <p:cNvSpPr txBox="1"/>
            <p:nvPr/>
          </p:nvSpPr>
          <p:spPr>
            <a:xfrm>
              <a:off x="4351340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3062E5-2267-4FDE-9926-600AF3445427}"/>
                </a:ext>
              </a:extLst>
            </p:cNvPr>
            <p:cNvSpPr txBox="1"/>
            <p:nvPr/>
          </p:nvSpPr>
          <p:spPr>
            <a:xfrm>
              <a:off x="465302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9EF9D8F-10D8-4C76-A5D9-F4F9338621A2}"/>
                </a:ext>
              </a:extLst>
            </p:cNvPr>
            <p:cNvSpPr txBox="1"/>
            <p:nvPr/>
          </p:nvSpPr>
          <p:spPr>
            <a:xfrm>
              <a:off x="4963856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A9A3FDB-A500-4BEF-AB90-A58856393C0B}"/>
                </a:ext>
              </a:extLst>
            </p:cNvPr>
            <p:cNvSpPr txBox="1"/>
            <p:nvPr/>
          </p:nvSpPr>
          <p:spPr>
            <a:xfrm>
              <a:off x="5317591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6F652A4-5749-4585-A212-E2E04AD50B01}"/>
                </a:ext>
              </a:extLst>
            </p:cNvPr>
            <p:cNvSpPr txBox="1"/>
            <p:nvPr/>
          </p:nvSpPr>
          <p:spPr>
            <a:xfrm>
              <a:off x="5662785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1888E71-DFBF-4B7F-B90A-DDCE5202D944}"/>
                </a:ext>
              </a:extLst>
            </p:cNvPr>
            <p:cNvSpPr txBox="1"/>
            <p:nvPr/>
          </p:nvSpPr>
          <p:spPr>
            <a:xfrm>
              <a:off x="5999383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495E67F-9108-4E65-A76C-EA372B5F9EB8}"/>
                </a:ext>
              </a:extLst>
            </p:cNvPr>
            <p:cNvSpPr txBox="1"/>
            <p:nvPr/>
          </p:nvSpPr>
          <p:spPr>
            <a:xfrm>
              <a:off x="6310213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AE16A4E-59A6-4CD3-B13D-B10D80244ED0}"/>
                </a:ext>
              </a:extLst>
            </p:cNvPr>
            <p:cNvSpPr txBox="1"/>
            <p:nvPr/>
          </p:nvSpPr>
          <p:spPr>
            <a:xfrm>
              <a:off x="6663948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E5B253A-BFF5-4308-8081-E995D9D79B34}"/>
                </a:ext>
              </a:extLst>
            </p:cNvPr>
            <p:cNvSpPr txBox="1"/>
            <p:nvPr/>
          </p:nvSpPr>
          <p:spPr>
            <a:xfrm>
              <a:off x="7009142" y="501875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4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2E24EF46-0088-4D5A-AD2E-FF4700A2E1E1}"/>
                </a:ext>
              </a:extLst>
            </p:cNvPr>
            <p:cNvCxnSpPr/>
            <p:nvPr/>
          </p:nvCxnSpPr>
          <p:spPr>
            <a:xfrm>
              <a:off x="3323293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21AC3800-183F-4A90-9ACA-2BEDCF8C4B76}"/>
                </a:ext>
              </a:extLst>
            </p:cNvPr>
            <p:cNvCxnSpPr/>
            <p:nvPr/>
          </p:nvCxnSpPr>
          <p:spPr>
            <a:xfrm>
              <a:off x="4653026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61AF061F-47B0-44E7-AD8E-B2CD5E00913D}"/>
                </a:ext>
              </a:extLst>
            </p:cNvPr>
            <p:cNvCxnSpPr/>
            <p:nvPr/>
          </p:nvCxnSpPr>
          <p:spPr>
            <a:xfrm>
              <a:off x="6008225" y="5388088"/>
              <a:ext cx="1311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86B81AF-1509-4DFE-8425-9F0F5C95CF02}"/>
                </a:ext>
              </a:extLst>
            </p:cNvPr>
            <p:cNvSpPr txBox="1"/>
            <p:nvPr/>
          </p:nvSpPr>
          <p:spPr>
            <a:xfrm>
              <a:off x="3578103" y="5414654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/>
                <a:t>Whol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3D27923-47D9-4B5D-92A6-F497F13639EB}"/>
                </a:ext>
              </a:extLst>
            </p:cNvPr>
            <p:cNvSpPr txBox="1"/>
            <p:nvPr/>
          </p:nvSpPr>
          <p:spPr>
            <a:xfrm>
              <a:off x="4741335" y="5414654"/>
              <a:ext cx="874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Cytosol</a:t>
              </a:r>
              <a:endParaRPr lang="nb-NO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D8B02B0-63D4-44CC-BF57-12B71DC4C9AD}"/>
                </a:ext>
              </a:extLst>
            </p:cNvPr>
            <p:cNvSpPr txBox="1"/>
            <p:nvPr/>
          </p:nvSpPr>
          <p:spPr>
            <a:xfrm>
              <a:off x="6194156" y="5414654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err="1"/>
                <a:t>Nucleus</a:t>
              </a:r>
              <a:endParaRPr lang="nb-NO" dirty="0"/>
            </a:p>
          </p:txBody>
        </p:sp>
      </p:grpSp>
    </p:spTree>
    <p:extLst>
      <p:ext uri="{BB962C8B-B14F-4D97-AF65-F5344CB8AC3E}">
        <p14:creationId xmlns:p14="http://schemas.microsoft.com/office/powerpoint/2010/main" val="40714840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2F976817-06F4-4748-AE21-9F2297D2A7E7}"/>
              </a:ext>
            </a:extLst>
          </p:cNvPr>
          <p:cNvGrpSpPr/>
          <p:nvPr/>
        </p:nvGrpSpPr>
        <p:grpSpPr>
          <a:xfrm>
            <a:off x="3917580" y="1934753"/>
            <a:ext cx="4623826" cy="3146528"/>
            <a:chOff x="4067482" y="1012858"/>
            <a:chExt cx="4623826" cy="314652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461B941-D23A-4D25-87A2-C06EC0B1EADE}"/>
                </a:ext>
              </a:extLst>
            </p:cNvPr>
            <p:cNvSpPr txBox="1"/>
            <p:nvPr/>
          </p:nvSpPr>
          <p:spPr>
            <a:xfrm>
              <a:off x="4332991" y="1036338"/>
              <a:ext cx="15784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Anti-BclXL coIP</a:t>
              </a:r>
              <a:endParaRPr lang="en-GB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5EE03C5-183C-4A1C-90C1-DB3B815E2688}"/>
                </a:ext>
              </a:extLst>
            </p:cNvPr>
            <p:cNvSpPr txBox="1"/>
            <p:nvPr/>
          </p:nvSpPr>
          <p:spPr>
            <a:xfrm>
              <a:off x="6245902" y="1012858"/>
              <a:ext cx="6229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WCE</a:t>
              </a:r>
              <a:endParaRPr lang="en-GB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5A71DEB-A98E-4E3B-981B-14F8C6E81C25}"/>
                </a:ext>
              </a:extLst>
            </p:cNvPr>
            <p:cNvSpPr txBox="1"/>
            <p:nvPr/>
          </p:nvSpPr>
          <p:spPr>
            <a:xfrm>
              <a:off x="7370112" y="1533358"/>
              <a:ext cx="91082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/>
                <a:t>4-NQO</a:t>
              </a:r>
              <a:endParaRPr lang="fi-FI" sz="200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5883655-F4EF-4ACC-8462-1D8417A99C83}"/>
                </a:ext>
              </a:extLst>
            </p:cNvPr>
            <p:cNvSpPr txBox="1"/>
            <p:nvPr/>
          </p:nvSpPr>
          <p:spPr>
            <a:xfrm>
              <a:off x="7370112" y="1237590"/>
              <a:ext cx="13211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A-1155463</a:t>
              </a:r>
              <a:endParaRPr lang="fi-FI" sz="2000" dirty="0"/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A0B8F6A-06ED-4371-BA33-E1684A8B37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66487" y="1306463"/>
              <a:ext cx="2951958" cy="62700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4266" t="53086" r="11167" b="34442"/>
            <a:stretch/>
          </p:blipFill>
          <p:spPr>
            <a:xfrm>
              <a:off x="4094132" y="2427088"/>
              <a:ext cx="3188780" cy="493301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7516489" y="2507814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BclXL</a:t>
              </a: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18318" t="20975" r="4218" b="64344"/>
            <a:stretch/>
          </p:blipFill>
          <p:spPr>
            <a:xfrm>
              <a:off x="4152121" y="3371199"/>
              <a:ext cx="3130791" cy="253983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7494285" y="3328739"/>
              <a:ext cx="560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BAX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471843" y="3034754"/>
              <a:ext cx="583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BAD</a:t>
              </a: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30695" t="33530" r="8710" b="57396"/>
            <a:stretch/>
          </p:blipFill>
          <p:spPr>
            <a:xfrm>
              <a:off x="4096139" y="1978090"/>
              <a:ext cx="3164450" cy="393424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7494285" y="1943392"/>
              <a:ext cx="540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p53</a:t>
              </a: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9"/>
            <a:srcRect l="23424" t="49508" r="13499" b="40373"/>
            <a:stretch/>
          </p:blipFill>
          <p:spPr>
            <a:xfrm>
              <a:off x="4067482" y="3748833"/>
              <a:ext cx="3193107" cy="410553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452001" y="3728409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-FI" dirty="0"/>
                <a:t>GAPDH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10"/>
            <a:srcRect t="19022"/>
            <a:stretch/>
          </p:blipFill>
          <p:spPr>
            <a:xfrm>
              <a:off x="4111749" y="2951321"/>
              <a:ext cx="3208149" cy="244130"/>
            </a:xfrm>
            <a:prstGeom prst="rect">
              <a:avLst/>
            </a:prstGeom>
          </p:spPr>
        </p:pic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32F963AA-8D63-43B9-A510-250B9B74F776}"/>
              </a:ext>
            </a:extLst>
          </p:cNvPr>
          <p:cNvSpPr txBox="1"/>
          <p:nvPr/>
        </p:nvSpPr>
        <p:spPr>
          <a:xfrm>
            <a:off x="1406926" y="560970"/>
            <a:ext cx="1439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3600" b="1" dirty="0"/>
              <a:t>Fig. 4d</a:t>
            </a:r>
            <a:endParaRPr lang="nb-NO" sz="3600" b="1" dirty="0"/>
          </a:p>
        </p:txBody>
      </p:sp>
    </p:spTree>
    <p:extLst>
      <p:ext uri="{BB962C8B-B14F-4D97-AF65-F5344CB8AC3E}">
        <p14:creationId xmlns:p14="http://schemas.microsoft.com/office/powerpoint/2010/main" val="31263155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8633" y="766903"/>
            <a:ext cx="10515600" cy="1325563"/>
          </a:xfrm>
        </p:spPr>
        <p:txBody>
          <a:bodyPr/>
          <a:lstStyle/>
          <a:p>
            <a:pPr algn="ctr"/>
            <a:r>
              <a:rPr lang="fi-FI" dirty="0" err="1"/>
              <a:t>AntiBclXL</a:t>
            </a:r>
            <a:endParaRPr lang="fi-FI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1"/>
          <a:stretch/>
        </p:blipFill>
        <p:spPr>
          <a:xfrm>
            <a:off x="3372787" y="1786814"/>
            <a:ext cx="3799907" cy="3284371"/>
          </a:xfrm>
          <a:prstGeom prst="rect">
            <a:avLst/>
          </a:prstGeom>
        </p:spPr>
      </p:pic>
      <p:cxnSp>
        <p:nvCxnSpPr>
          <p:cNvPr id="10" name="Straight Arrow Connector 9"/>
          <p:cNvCxnSpPr/>
          <p:nvPr/>
        </p:nvCxnSpPr>
        <p:spPr>
          <a:xfrm flipH="1">
            <a:off x="6714024" y="3723680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076618" y="3539014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Bcl</a:t>
            </a:r>
            <a:r>
              <a:rPr lang="en-US" dirty="0"/>
              <a:t>-XL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4700825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7688" y="830987"/>
            <a:ext cx="10515600" cy="1325563"/>
          </a:xfrm>
        </p:spPr>
        <p:txBody>
          <a:bodyPr/>
          <a:lstStyle/>
          <a:p>
            <a:r>
              <a:rPr lang="en-US" dirty="0"/>
              <a:t>GAPDH</a:t>
            </a:r>
            <a:endParaRPr lang="fi-FI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298" y="1854708"/>
            <a:ext cx="3934968" cy="3148584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H="1">
            <a:off x="7384182" y="3575765"/>
            <a:ext cx="382385" cy="831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746776" y="339109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188582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4</Words>
  <Application>Microsoft Office PowerPoint</Application>
  <PresentationFormat>Widescreen</PresentationFormat>
  <Paragraphs>224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AntiBclXL</vt:lpstr>
      <vt:lpstr>GAPDH</vt:lpstr>
      <vt:lpstr>P53, GAPDH, Bcl-xL</vt:lpstr>
      <vt:lpstr>antiBAD</vt:lpstr>
      <vt:lpstr>antiBAX(Rab)</vt:lpstr>
      <vt:lpstr>Fig. 5a</vt:lpstr>
      <vt:lpstr>PowerPoint Presentation</vt:lpstr>
      <vt:lpstr>PowerPoint Presentation</vt:lpstr>
      <vt:lpstr>Fig. 6c</vt:lpstr>
      <vt:lpstr>P53 and GAPDH</vt:lpstr>
      <vt:lpstr>p53 and GAPDH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 Wang</dc:creator>
  <cp:lastModifiedBy>Denis Kainov</cp:lastModifiedBy>
  <cp:revision>25</cp:revision>
  <dcterms:created xsi:type="dcterms:W3CDTF">2020-04-23T12:32:40Z</dcterms:created>
  <dcterms:modified xsi:type="dcterms:W3CDTF">2020-06-12T12:44:40Z</dcterms:modified>
</cp:coreProperties>
</file>